
<file path=[Content_Types].xml><?xml version="1.0" encoding="utf-8"?>
<Types xmlns="http://schemas.openxmlformats.org/package/2006/content-types">
  <Default Extension="emf" ContentType="image/x-emf"/>
  <Override PartName="/docProps/core.xml" ContentType="application/vnd.openxmlformats-package.core-properties+xml"/>
  <Override PartName="/ppt/slideLayouts/slideLayout6.xml" ContentType="application/vnd.openxmlformats-officedocument.presentationml.slideLayout+xml"/>
  <Default Extension="rels" ContentType="application/vnd.openxmlformats-package.relationships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sldIdLst>
    <p:sldId id="256" r:id="rId2"/>
  </p:sldIdLst>
  <p:sldSz cx="9906000" cy="6858000" type="A4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:p="http://schemas.openxmlformats.org/presentationml/2006/main" xmlns:r="http://schemas.openxmlformats.org/officeDocument/2006/relationships" xmlns:a="http://schemas.openxmlformats.org/drawingml/2006/main" xmlns="">
        <p15:guide id="1" orient="horz" pos="1026" userDrawn="1">
          <p15:clr>
            <a:srgbClr val="A4A3A4"/>
          </p15:clr>
        </p15:guide>
        <p15:guide id="2" pos="477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extLst>
    <p:ext uri="{E76CE94A-603C-4142-B9EB-6D1370010A27}">
      <p14:discardImageEditData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0"/>
    </p:ext>
    <p:ext uri="{D31A062A-798A-4329-ABDD-BBA856620510}">
      <p14:defaultImageDpi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20"/>
    </p:ext>
    <p:ext uri="{FD5EFAAD-0ECE-453E-9831-46B23BE46B34}">
      <p15:chartTrackingRefBased xmlns:p15="http://schemas.microsoft.com/office/powerpoint/2012/main" xmlns:p="http://schemas.openxmlformats.org/presentationml/2006/main" xmlns:r="http://schemas.openxmlformats.org/officeDocument/2006/relationships" xmlns:a="http://schemas.openxmlformats.org/drawingml/2006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>
    <p:restoredLeft sz="19251"/>
    <p:restoredTop sz="94687"/>
  </p:normalViewPr>
  <p:slideViewPr>
    <p:cSldViewPr snapToGrid="0" snapToObjects="1" showGuides="1">
      <p:cViewPr>
        <p:scale>
          <a:sx n="66" d="100"/>
          <a:sy n="66" d="100"/>
        </p:scale>
        <p:origin x="-1152" y="-152"/>
      </p:cViewPr>
      <p:guideLst>
        <p:guide orient="horz" pos="2942"/>
        <p:guide pos="4776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57A81-B43B-CB41-BB0A-2F05D3ABB299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EDE1B9-0531-B248-BA19-B85C3426E3D3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57A81-B43B-CB41-BB0A-2F05D3ABB299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EDE1B9-0531-B248-BA19-B85C3426E3D3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7780337" y="274639"/>
            <a:ext cx="2414588" cy="5851525"/>
          </a:xfrm>
        </p:spPr>
        <p:txBody>
          <a:bodyPr vert="eaVert"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536575" y="274639"/>
            <a:ext cx="7078663" cy="5851525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57A81-B43B-CB41-BB0A-2F05D3ABB299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EDE1B9-0531-B248-BA19-B85C3426E3D3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57A81-B43B-CB41-BB0A-2F05D3ABB299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EDE1B9-0531-B248-BA19-B85C3426E3D3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57A81-B43B-CB41-BB0A-2F05D3ABB299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EDE1B9-0531-B248-BA19-B85C3426E3D3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536575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5448300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57A81-B43B-CB41-BB0A-2F05D3ABB299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EDE1B9-0531-B248-BA19-B85C3426E3D3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57A81-B43B-CB41-BB0A-2F05D3ABB299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EDE1B9-0531-B248-BA19-B85C3426E3D3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57A81-B43B-CB41-BB0A-2F05D3ABB299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EDE1B9-0531-B248-BA19-B85C3426E3D3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57A81-B43B-CB41-BB0A-2F05D3ABB299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EDE1B9-0531-B248-BA19-B85C3426E3D3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57A81-B43B-CB41-BB0A-2F05D3ABB299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EDE1B9-0531-B248-BA19-B85C3426E3D3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57A81-B43B-CB41-BB0A-2F05D3ABB299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EDE1B9-0531-B248-BA19-B85C3426E3D3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D57A81-B43B-CB41-BB0A-2F05D3ABB299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EDE1B9-0531-B248-BA19-B85C3426E3D3}" type="slidenum">
              <a:rPr lang="fr-FR" smtClean="0"/>
              <a:pPr/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9" name="Grouper 268"/>
          <p:cNvGrpSpPr/>
          <p:nvPr/>
        </p:nvGrpSpPr>
        <p:grpSpPr>
          <a:xfrm>
            <a:off x="151758" y="90956"/>
            <a:ext cx="9587721" cy="6740395"/>
            <a:chOff x="151758" y="90956"/>
            <a:chExt cx="9587721" cy="6740395"/>
          </a:xfrm>
        </p:grpSpPr>
        <p:sp>
          <p:nvSpPr>
            <p:cNvPr id="265" name="TextBox 25">
              <a:extLst>
                <a:ext uri="{FF2B5EF4-FFF2-40B4-BE49-F238E27FC236}">
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3EFA0AB1-9841-AA47-A9CB-BADEE4F9DD12}"/>
                </a:ext>
              </a:extLst>
            </p:cNvPr>
            <p:cNvSpPr txBox="1"/>
            <p:nvPr/>
          </p:nvSpPr>
          <p:spPr>
            <a:xfrm>
              <a:off x="151758" y="6537999"/>
              <a:ext cx="4884329" cy="169277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just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S5 Fig. </a:t>
              </a:r>
              <a:r>
                <a:rPr lang="en-GB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Low 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binding of </a:t>
              </a:r>
              <a:r>
                <a:rPr lang="en-US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erR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with the </a:t>
              </a:r>
              <a:r>
                <a:rPr lang="en-US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erR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controlled peroxidase locus.</a:t>
              </a:r>
              <a:r>
                <a:rPr lang="fr-FR" sz="1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grpSp>
          <p:nvGrpSpPr>
            <p:cNvPr id="266" name="Grouper 265"/>
            <p:cNvGrpSpPr/>
            <p:nvPr/>
          </p:nvGrpSpPr>
          <p:grpSpPr>
            <a:xfrm>
              <a:off x="355443" y="90956"/>
              <a:ext cx="9345071" cy="2084068"/>
              <a:chOff x="355443" y="90956"/>
              <a:chExt cx="9345071" cy="2084068"/>
            </a:xfrm>
          </p:grpSpPr>
          <p:grpSp>
            <p:nvGrpSpPr>
              <p:cNvPr id="4" name="Groupe 3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B0D3DA04-008F-3B48-925C-D82618DD7838}"/>
                  </a:ext>
                </a:extLst>
              </p:cNvPr>
              <p:cNvGrpSpPr/>
              <p:nvPr/>
            </p:nvGrpSpPr>
            <p:grpSpPr>
              <a:xfrm>
                <a:off x="811503" y="90956"/>
                <a:ext cx="8889011" cy="2084068"/>
                <a:chOff x="811503" y="90956"/>
                <a:chExt cx="8889011" cy="2084068"/>
              </a:xfrm>
            </p:grpSpPr>
            <p:grpSp>
              <p:nvGrpSpPr>
                <p:cNvPr id="23" name="Groupe 22">
                  <a:extLst>
                    <a:ext uri="{FF2B5EF4-FFF2-40B4-BE49-F238E27FC236}">
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C48F1785-B685-5149-B5D1-B7B69EE54CBC}"/>
                    </a:ext>
                  </a:extLst>
                </p:cNvPr>
                <p:cNvGrpSpPr/>
                <p:nvPr/>
              </p:nvGrpSpPr>
              <p:grpSpPr>
                <a:xfrm>
                  <a:off x="811503" y="654841"/>
                  <a:ext cx="3402899" cy="736005"/>
                  <a:chOff x="811503" y="654841"/>
                  <a:chExt cx="3402899" cy="736005"/>
                </a:xfrm>
              </p:grpSpPr>
              <p:grpSp>
                <p:nvGrpSpPr>
                  <p:cNvPr id="187" name="Grouper 186"/>
                  <p:cNvGrpSpPr/>
                  <p:nvPr/>
                </p:nvGrpSpPr>
                <p:grpSpPr>
                  <a:xfrm>
                    <a:off x="811503" y="654841"/>
                    <a:ext cx="3402899" cy="736005"/>
                    <a:chOff x="516794" y="828064"/>
                    <a:chExt cx="3402899" cy="736005"/>
                  </a:xfrm>
                </p:grpSpPr>
                <p:grpSp>
                  <p:nvGrpSpPr>
                    <p:cNvPr id="188" name="Grouper 206"/>
                    <p:cNvGrpSpPr/>
                    <p:nvPr/>
                  </p:nvGrpSpPr>
                  <p:grpSpPr>
                    <a:xfrm>
                      <a:off x="720178" y="836876"/>
                      <a:ext cx="1083907" cy="349424"/>
                      <a:chOff x="720178" y="836876"/>
                      <a:chExt cx="1083907" cy="349424"/>
                    </a:xfrm>
                  </p:grpSpPr>
                  <p:sp>
                    <p:nvSpPr>
                      <p:cNvPr id="218" name="TextBox 23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13C4D056-344F-404B-B797-86232494965D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051621" y="836876"/>
                        <a:ext cx="421022" cy="153888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lIns="0" tIns="0" rIns="0" bIns="0" rtlCol="0">
                        <a:spAutoFit/>
                      </a:bodyPr>
                      <a:lstStyle/>
                      <a:p>
                        <a:pPr algn="ctr"/>
                        <a:r>
                          <a:rPr lang="en-US" sz="10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 </a:t>
                        </a:r>
                        <a:r>
                          <a:rPr lang="en-US" sz="1000" b="1" i="1" dirty="0" err="1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katE</a:t>
                        </a:r>
                        <a:endParaRPr lang="en-US" sz="1000" b="1" i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219" name="TextBox 20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D90D51D4-C5BA-5048-8AD6-22CB9DEBB6A9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720178" y="1032412"/>
                        <a:ext cx="1083907" cy="153888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lIns="0" tIns="0" rIns="0" bIns="0" rtlCol="0">
                        <a:spAutoFit/>
                      </a:bodyPr>
                      <a:lstStyle/>
                      <a:p>
                        <a:pPr algn="ctr"/>
                        <a:r>
                          <a:rPr lang="en-US" sz="10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LIMLP_10145</a:t>
                        </a:r>
                      </a:p>
                    </p:txBody>
                  </p:sp>
                </p:grpSp>
                <p:grpSp>
                  <p:nvGrpSpPr>
                    <p:cNvPr id="189" name="Grouper 204"/>
                    <p:cNvGrpSpPr/>
                    <p:nvPr/>
                  </p:nvGrpSpPr>
                  <p:grpSpPr>
                    <a:xfrm>
                      <a:off x="2911275" y="828064"/>
                      <a:ext cx="1008418" cy="349425"/>
                      <a:chOff x="2911275" y="828064"/>
                      <a:chExt cx="1008418" cy="349425"/>
                    </a:xfrm>
                  </p:grpSpPr>
                  <p:sp>
                    <p:nvSpPr>
                      <p:cNvPr id="216" name="TextBox 25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3D16B083-FB0D-5547-8C38-DB2DAFEBEB36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084866" y="828064"/>
                        <a:ext cx="661237" cy="153888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lIns="0" tIns="0" rIns="0" bIns="0" rtlCol="0">
                        <a:spAutoFit/>
                      </a:bodyPr>
                      <a:lstStyle/>
                      <a:p>
                        <a:pPr algn="ctr"/>
                        <a:r>
                          <a:rPr lang="en-US" sz="1000" b="1" i="1" dirty="0" err="1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perR</a:t>
                        </a:r>
                        <a:endParaRPr lang="en-US" sz="1000" b="1" i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217" name="TextBox 20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F75B731B-029D-494E-AE51-77F18E3AD27F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911275" y="1023601"/>
                        <a:ext cx="1008418" cy="153888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lIns="0" tIns="0" rIns="0" bIns="0" rtlCol="0">
                        <a:spAutoFit/>
                      </a:bodyPr>
                      <a:lstStyle/>
                      <a:p>
                        <a:pPr algn="ctr"/>
                        <a:r>
                          <a:rPr lang="en-US" sz="10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LIMLP_10155</a:t>
                        </a:r>
                      </a:p>
                    </p:txBody>
                  </p:sp>
                </p:grpSp>
                <p:grpSp>
                  <p:nvGrpSpPr>
                    <p:cNvPr id="190" name="Grouper 205"/>
                    <p:cNvGrpSpPr/>
                    <p:nvPr/>
                  </p:nvGrpSpPr>
                  <p:grpSpPr>
                    <a:xfrm>
                      <a:off x="1775153" y="828065"/>
                      <a:ext cx="876856" cy="349424"/>
                      <a:chOff x="1775153" y="828065"/>
                      <a:chExt cx="876856" cy="349424"/>
                    </a:xfrm>
                  </p:grpSpPr>
                  <p:sp>
                    <p:nvSpPr>
                      <p:cNvPr id="214" name="TextBox 24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CFF72D2A-C10B-E944-985C-4F5A0C03A5C7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010621" y="828065"/>
                        <a:ext cx="405919" cy="153888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lIns="0" tIns="0" rIns="0" bIns="0" rtlCol="0">
                        <a:spAutoFit/>
                      </a:bodyPr>
                      <a:lstStyle/>
                      <a:p>
                        <a:pPr algn="ctr"/>
                        <a:r>
                          <a:rPr lang="en-US" sz="1000" b="1" i="1" dirty="0" err="1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ank</a:t>
                        </a:r>
                        <a:endParaRPr lang="en-US" sz="1000" b="1" i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215" name="TextBox 20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100BF287-828D-1444-B3C2-F752BB52B8ED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775153" y="1023601"/>
                        <a:ext cx="876856" cy="153888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lIns="0" tIns="0" rIns="0" bIns="0" rtlCol="0">
                        <a:spAutoFit/>
                      </a:bodyPr>
                      <a:lstStyle/>
                      <a:p>
                        <a:pPr algn="ctr"/>
                        <a:r>
                          <a:rPr lang="en-US" sz="10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LIMLP_10150</a:t>
                        </a:r>
                      </a:p>
                    </p:txBody>
                  </p:sp>
                </p:grpSp>
                <p:grpSp>
                  <p:nvGrpSpPr>
                    <p:cNvPr id="191" name="Grouper 58"/>
                    <p:cNvGrpSpPr/>
                    <p:nvPr/>
                  </p:nvGrpSpPr>
                  <p:grpSpPr>
                    <a:xfrm>
                      <a:off x="516794" y="1185142"/>
                      <a:ext cx="3143046" cy="378927"/>
                      <a:chOff x="268869" y="1882916"/>
                      <a:chExt cx="7142267" cy="653238"/>
                    </a:xfrm>
                  </p:grpSpPr>
                  <p:cxnSp>
                    <p:nvCxnSpPr>
                      <p:cNvPr id="192" name="Straight Connector 10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9238ADF0-5D2A-EE4E-A464-DE64EB668F82}"/>
                          </a:ext>
                        </a:extLst>
                      </p:cNvPr>
                      <p:cNvCxnSpPr>
                        <a:cxnSpLocks noChangeAspect="1"/>
                      </p:cNvCxnSpPr>
                      <p:nvPr/>
                    </p:nvCxnSpPr>
                    <p:spPr>
                      <a:xfrm flipV="1">
                        <a:off x="4565903" y="2026044"/>
                        <a:ext cx="2045163" cy="7487"/>
                      </a:xfrm>
                      <a:prstGeom prst="line">
                        <a:avLst/>
                      </a:prstGeom>
                      <a:ln w="12700">
                        <a:headEnd type="none" w="med" len="med"/>
                        <a:tailEnd type="none" w="med" len="med"/>
                      </a:ln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93" name="Down Arrow 12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67662D05-0967-0D47-A206-51E7C02AB264}"/>
                          </a:ext>
                        </a:extLst>
                      </p:cNvPr>
                      <p:cNvSpPr>
                        <a:spLocks/>
                      </p:cNvSpPr>
                      <p:nvPr/>
                    </p:nvSpPr>
                    <p:spPr>
                      <a:xfrm rot="16200000">
                        <a:off x="6749531" y="1505321"/>
                        <a:ext cx="279209" cy="1044000"/>
                      </a:xfrm>
                      <a:prstGeom prst="downArrow">
                        <a:avLst>
                          <a:gd name="adj1" fmla="val 56250"/>
                          <a:gd name="adj2" fmla="val 50000"/>
                        </a:avLst>
                      </a:prstGeom>
                      <a:solidFill>
                        <a:srgbClr val="000000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vert="vert270" rtlCol="0" anchor="ctr"/>
                      <a:lstStyle/>
                      <a:p>
                        <a:pPr algn="ctr"/>
                        <a:endPara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94" name="Down Arrow 14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01B76F58-635A-B449-813B-AC539E25A753}"/>
                          </a:ext>
                        </a:extLst>
                      </p:cNvPr>
                      <p:cNvSpPr>
                        <a:spLocks/>
                      </p:cNvSpPr>
                      <p:nvPr/>
                    </p:nvSpPr>
                    <p:spPr>
                      <a:xfrm rot="5400000">
                        <a:off x="1744464" y="407321"/>
                        <a:ext cx="288809" cy="3240000"/>
                      </a:xfrm>
                      <a:prstGeom prst="downArrow">
                        <a:avLst/>
                      </a:prstGeom>
                      <a:solidFill>
                        <a:srgbClr val="000000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vert="vert270" rtlCol="0" anchor="ctr"/>
                      <a:lstStyle/>
                      <a:p>
                        <a:pPr algn="ctr"/>
                        <a:endParaRPr lang="en-US" sz="1000" b="1" dirty="0">
                          <a:solidFill>
                            <a:srgbClr val="FFFF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95" name="Down Arrow 14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B8E0DCBB-A667-A642-93EB-5B742502C91E}"/>
                          </a:ext>
                        </a:extLst>
                      </p:cNvPr>
                      <p:cNvSpPr>
                        <a:spLocks/>
                      </p:cNvSpPr>
                      <p:nvPr/>
                    </p:nvSpPr>
                    <p:spPr>
                      <a:xfrm rot="5400000">
                        <a:off x="3907771" y="1487321"/>
                        <a:ext cx="288809" cy="1080000"/>
                      </a:xfrm>
                      <a:prstGeom prst="downArrow">
                        <a:avLst/>
                      </a:prstGeom>
                      <a:solidFill>
                        <a:srgbClr val="000000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vert="vert270" rtlCol="0" anchor="ctr"/>
                      <a:lstStyle/>
                      <a:p>
                        <a:pPr algn="ctr"/>
                        <a:endParaRPr lang="en-US" sz="1000" b="1" dirty="0">
                          <a:solidFill>
                            <a:srgbClr val="FFFF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grpSp>
                    <p:nvGrpSpPr>
                      <p:cNvPr id="196" name="Groupe 63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B38D4BE7-3069-384F-B302-0C37ACF9E3BD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3809840" y="2191127"/>
                        <a:ext cx="509405" cy="345027"/>
                        <a:chOff x="5111901" y="2169365"/>
                        <a:chExt cx="509405" cy="345027"/>
                      </a:xfrm>
                    </p:grpSpPr>
                    <p:sp>
                      <p:nvSpPr>
                        <p:cNvPr id="212" name="TextBox 25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14034987-C35B-8D44-90E0-7B29F2870E17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111901" y="2250343"/>
                          <a:ext cx="509405" cy="26404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lIns="0" tIns="0" rIns="0" bIns="0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sz="1000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11</a:t>
                          </a:r>
                        </a:p>
                      </p:txBody>
                    </p:sp>
                    <p:cxnSp>
                      <p:nvCxnSpPr>
                        <p:cNvPr id="213" name="Connecteur droit avec flèche 212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0D4DE2C3-9D58-E349-B901-7F84BCF5BC0A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5186888" y="2169365"/>
                          <a:ext cx="356829" cy="0"/>
                        </a:xfrm>
                        <a:prstGeom prst="straightConnector1">
                          <a:avLst/>
                        </a:prstGeom>
                        <a:ln w="1905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  <p:grpSp>
                    <p:nvGrpSpPr>
                      <p:cNvPr id="197" name="Groupe 63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B38D4BE7-3069-384F-B302-0C37ACF9E3BD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666333" y="2191128"/>
                        <a:ext cx="509405" cy="345024"/>
                        <a:chOff x="5111901" y="2251416"/>
                        <a:chExt cx="509405" cy="345024"/>
                      </a:xfrm>
                    </p:grpSpPr>
                    <p:sp>
                      <p:nvSpPr>
                        <p:cNvPr id="210" name="TextBox 25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14034987-C35B-8D44-90E0-7B29F2870E17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111901" y="2332393"/>
                          <a:ext cx="509405" cy="26404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lIns="0" tIns="0" rIns="0" bIns="0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sz="1000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5</a:t>
                          </a:r>
                        </a:p>
                      </p:txBody>
                    </p:sp>
                    <p:cxnSp>
                      <p:nvCxnSpPr>
                        <p:cNvPr id="211" name="Connecteur droit avec flèche 210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0D4DE2C3-9D58-E349-B901-7F84BCF5BC0A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5186888" y="2251416"/>
                          <a:ext cx="356829" cy="0"/>
                        </a:xfrm>
                        <a:prstGeom prst="straightConnector1">
                          <a:avLst/>
                        </a:prstGeom>
                        <a:ln w="1905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  <p:grpSp>
                    <p:nvGrpSpPr>
                      <p:cNvPr id="198" name="Groupe 63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B38D4BE7-3069-384F-B302-0C37ACF9E3BD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247233" y="2191128"/>
                        <a:ext cx="509405" cy="345024"/>
                        <a:chOff x="5111901" y="2251416"/>
                        <a:chExt cx="509405" cy="345024"/>
                      </a:xfrm>
                    </p:grpSpPr>
                    <p:sp>
                      <p:nvSpPr>
                        <p:cNvPr id="208" name="TextBox 25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14034987-C35B-8D44-90E0-7B29F2870E17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111901" y="2332393"/>
                          <a:ext cx="509405" cy="26404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lIns="0" tIns="0" rIns="0" bIns="0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sz="1000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9</a:t>
                          </a:r>
                        </a:p>
                      </p:txBody>
                    </p:sp>
                    <p:cxnSp>
                      <p:nvCxnSpPr>
                        <p:cNvPr id="209" name="Connecteur droit avec flèche 208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0D4DE2C3-9D58-E349-B901-7F84BCF5BC0A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5186888" y="2251416"/>
                          <a:ext cx="356829" cy="0"/>
                        </a:xfrm>
                        <a:prstGeom prst="straightConnector1">
                          <a:avLst/>
                        </a:prstGeom>
                        <a:ln w="1905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  <p:grpSp>
                    <p:nvGrpSpPr>
                      <p:cNvPr id="199" name="Groupe 63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B38D4BE7-3069-384F-B302-0C37ACF9E3BD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1866233" y="2191128"/>
                        <a:ext cx="509405" cy="345024"/>
                        <a:chOff x="5111901" y="2251416"/>
                        <a:chExt cx="509405" cy="345024"/>
                      </a:xfrm>
                    </p:grpSpPr>
                    <p:sp>
                      <p:nvSpPr>
                        <p:cNvPr id="206" name="TextBox 25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14034987-C35B-8D44-90E0-7B29F2870E17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111901" y="2332393"/>
                          <a:ext cx="509405" cy="26404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lIns="0" tIns="0" rIns="0" bIns="0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sz="1000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12</a:t>
                          </a:r>
                        </a:p>
                      </p:txBody>
                    </p:sp>
                    <p:cxnSp>
                      <p:nvCxnSpPr>
                        <p:cNvPr id="207" name="Connecteur droit avec flèche 206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0D4DE2C3-9D58-E349-B901-7F84BCF5BC0A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5186888" y="2251416"/>
                          <a:ext cx="356829" cy="0"/>
                        </a:xfrm>
                        <a:prstGeom prst="straightConnector1">
                          <a:avLst/>
                        </a:prstGeom>
                        <a:ln w="1905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  <p:grpSp>
                    <p:nvGrpSpPr>
                      <p:cNvPr id="200" name="Groupe 63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B38D4BE7-3069-384F-B302-0C37ACF9E3BD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596233" y="2191128"/>
                        <a:ext cx="509405" cy="345024"/>
                        <a:chOff x="5111901" y="2251416"/>
                        <a:chExt cx="509405" cy="345024"/>
                      </a:xfrm>
                    </p:grpSpPr>
                    <p:sp>
                      <p:nvSpPr>
                        <p:cNvPr id="204" name="TextBox 25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14034987-C35B-8D44-90E0-7B29F2870E17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111901" y="2332393"/>
                          <a:ext cx="509405" cy="26404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lIns="0" tIns="0" rIns="0" bIns="0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sz="1000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1</a:t>
                          </a:r>
                        </a:p>
                      </p:txBody>
                    </p:sp>
                    <p:cxnSp>
                      <p:nvCxnSpPr>
                        <p:cNvPr id="205" name="Connecteur droit avec flèche 204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0D4DE2C3-9D58-E349-B901-7F84BCF5BC0A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5186888" y="2251416"/>
                          <a:ext cx="356829" cy="0"/>
                        </a:xfrm>
                        <a:prstGeom prst="straightConnector1">
                          <a:avLst/>
                        </a:prstGeom>
                        <a:ln w="1905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</p:grpSp>
              </p:grpSp>
              <p:sp>
                <p:nvSpPr>
                  <p:cNvPr id="250" name="TextBox 25">
                    <a:extLst>
                      <a:ext uri="{FF2B5EF4-FFF2-40B4-BE49-F238E27FC236}">
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7A7E9930-D4A1-EE42-8219-7F62C717FFBB}"/>
                      </a:ext>
                    </a:extLst>
                  </p:cNvPr>
                  <p:cNvSpPr txBox="1"/>
                  <p:nvPr/>
                </p:nvSpPr>
                <p:spPr>
                  <a:xfrm>
                    <a:off x="2991875" y="933395"/>
                    <a:ext cx="224170" cy="123111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b="1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91</a:t>
                    </a:r>
                  </a:p>
                </p:txBody>
              </p:sp>
            </p:grpSp>
            <p:grpSp>
              <p:nvGrpSpPr>
                <p:cNvPr id="2" name="Groupe 1">
                  <a:extLst>
                    <a:ext uri="{FF2B5EF4-FFF2-40B4-BE49-F238E27FC236}">
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AD87025E-F83F-F545-8946-69AE73C3B326}"/>
                    </a:ext>
                  </a:extLst>
                </p:cNvPr>
                <p:cNvGrpSpPr/>
                <p:nvPr/>
              </p:nvGrpSpPr>
              <p:grpSpPr>
                <a:xfrm>
                  <a:off x="4819577" y="90956"/>
                  <a:ext cx="4880937" cy="2084068"/>
                  <a:chOff x="4819577" y="90956"/>
                  <a:chExt cx="4880937" cy="2084068"/>
                </a:xfrm>
              </p:grpSpPr>
              <p:grpSp>
                <p:nvGrpSpPr>
                  <p:cNvPr id="155" name="Groupe 154">
                    <a:extLst>
                      <a:ext uri="{FF2B5EF4-FFF2-40B4-BE49-F238E27FC236}">
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6AB29B12-E7E7-554D-958E-9542F79F91E3}"/>
                      </a:ext>
                    </a:extLst>
                  </p:cNvPr>
                  <p:cNvGrpSpPr/>
                  <p:nvPr/>
                </p:nvGrpSpPr>
                <p:grpSpPr>
                  <a:xfrm>
                    <a:off x="4819577" y="90956"/>
                    <a:ext cx="4333583" cy="2084068"/>
                    <a:chOff x="4818961" y="84345"/>
                    <a:chExt cx="4333583" cy="2084068"/>
                  </a:xfrm>
                </p:grpSpPr>
                <p:grpSp>
                  <p:nvGrpSpPr>
                    <p:cNvPr id="134" name="Groupe 133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87175F55-7716-E043-982D-CEB1F214FE09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5311870" y="1348771"/>
                      <a:ext cx="815417" cy="815098"/>
                      <a:chOff x="5311870" y="1513661"/>
                      <a:chExt cx="815417" cy="815098"/>
                    </a:xfrm>
                  </p:grpSpPr>
                  <p:sp>
                    <p:nvSpPr>
                      <p:cNvPr id="222" name="Parenthèse ouvrante 221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93A3E82E-4844-EC4B-9BA8-645CCA6865E0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5645941" y="1711337"/>
                        <a:ext cx="80151" cy="668999"/>
                      </a:xfrm>
                      <a:prstGeom prst="leftBracket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fr-FR"/>
                      </a:p>
                    </p:txBody>
                  </p:sp>
                  <p:sp>
                    <p:nvSpPr>
                      <p:cNvPr id="223" name="ZoneTexte 222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BB379FED-2250-5A49-8491-E0888C57F494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5543181" y="2051760"/>
                        <a:ext cx="270251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fr-FR" sz="12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</a:t>
                        </a:r>
                      </a:p>
                    </p:txBody>
                  </p:sp>
                  <p:grpSp>
                    <p:nvGrpSpPr>
                      <p:cNvPr id="131" name="Groupe 130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22A8810F-AE07-544C-B9BB-C1E334B28D1F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5311870" y="1513661"/>
                        <a:ext cx="424903" cy="513209"/>
                        <a:chOff x="5311870" y="1513661"/>
                        <a:chExt cx="424903" cy="513209"/>
                      </a:xfrm>
                    </p:grpSpPr>
                    <p:grpSp>
                      <p:nvGrpSpPr>
                        <p:cNvPr id="130" name="Groupe 129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AB6B329A-1FC1-9049-8573-47DD6EF55EB8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5311870" y="1513661"/>
                          <a:ext cx="424903" cy="283349"/>
                          <a:chOff x="5311870" y="1513661"/>
                          <a:chExt cx="424903" cy="283349"/>
                        </a:xfrm>
                      </p:grpSpPr>
                      <p:sp>
                        <p:nvSpPr>
                          <p:cNvPr id="234" name="ZoneTexte 233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847B1F25-D2D1-8C40-BB45-B4E35B190343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5311870" y="1513661"/>
                            <a:ext cx="231779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-</a:t>
                            </a:r>
                          </a:p>
                        </p:txBody>
                      </p:sp>
                      <p:sp>
                        <p:nvSpPr>
                          <p:cNvPr id="235" name="ZoneTexte 234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9310CDDA-AF85-4D4F-A44A-D3F7999A947C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5475163" y="1520011"/>
                            <a:ext cx="261610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+</a:t>
                            </a:r>
                          </a:p>
                        </p:txBody>
                      </p:sp>
                      <p:sp>
                        <p:nvSpPr>
                          <p:cNvPr id="236" name="Parenthèse ouvrante 235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B28519C1-2B29-2640-9859-73301AD2007E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 rot="16200000">
                            <a:off x="5481000" y="1606960"/>
                            <a:ext cx="72000" cy="270000"/>
                          </a:xfrm>
                          <a:prstGeom prst="leftBracket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fr-FR"/>
                          </a:p>
                        </p:txBody>
                      </p:sp>
                    </p:grpSp>
                    <p:sp>
                      <p:nvSpPr>
                        <p:cNvPr id="233" name="ZoneTexte 232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FDD64D3B-E5FF-9547-9DFC-F91E6FA42C04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312833" y="1765260"/>
                          <a:ext cx="416801" cy="26161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fr-FR" sz="1100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WT</a:t>
                          </a:r>
                        </a:p>
                      </p:txBody>
                    </p:sp>
                  </p:grpSp>
                  <p:grpSp>
                    <p:nvGrpSpPr>
                      <p:cNvPr id="133" name="Groupe 132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9E5C5113-0611-BC40-941C-FEDCAAAF57CF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5581205" y="1520011"/>
                        <a:ext cx="546082" cy="506859"/>
                        <a:chOff x="5581205" y="1520011"/>
                        <a:chExt cx="546082" cy="506859"/>
                      </a:xfrm>
                    </p:grpSpPr>
                    <p:sp>
                      <p:nvSpPr>
                        <p:cNvPr id="227" name="ZoneTexte 226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3E5D07DE-750F-1C49-A023-381F4B9464A0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581205" y="1765260"/>
                          <a:ext cx="546082" cy="26161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fr-FR" sz="1100" b="1" i="1" dirty="0" err="1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perR</a:t>
                          </a:r>
                          <a:endParaRPr lang="fr-FR" sz="1100" b="1" i="1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grpSp>
                      <p:nvGrpSpPr>
                        <p:cNvPr id="129" name="Groupe 128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61481C53-88AD-C548-B995-FFD2B0A25AB1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5651168" y="1520011"/>
                          <a:ext cx="411135" cy="276999"/>
                          <a:chOff x="5651168" y="1520011"/>
                          <a:chExt cx="411135" cy="276999"/>
                        </a:xfrm>
                      </p:grpSpPr>
                      <p:sp>
                        <p:nvSpPr>
                          <p:cNvPr id="229" name="ZoneTexte 228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DEF0ADB6-14A9-504A-8674-7CC0D2D1B891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5651168" y="1520011"/>
                            <a:ext cx="231779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-</a:t>
                            </a:r>
                          </a:p>
                        </p:txBody>
                      </p:sp>
                      <p:sp>
                        <p:nvSpPr>
                          <p:cNvPr id="230" name="ZoneTexte 229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0098E67F-8005-0047-96F0-287A9E128219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5800693" y="1520011"/>
                            <a:ext cx="261610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+</a:t>
                            </a:r>
                          </a:p>
                        </p:txBody>
                      </p:sp>
                      <p:sp>
                        <p:nvSpPr>
                          <p:cNvPr id="231" name="Parenthèse ouvrante 230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B28519C1-2B29-2640-9859-73301AD2007E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 rot="16200000">
                            <a:off x="5807043" y="1606960"/>
                            <a:ext cx="72000" cy="270000"/>
                          </a:xfrm>
                          <a:prstGeom prst="leftBracket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fr-FR"/>
                          </a:p>
                        </p:txBody>
                      </p:sp>
                    </p:grpSp>
                  </p:grpSp>
                </p:grpSp>
                <p:pic>
                  <p:nvPicPr>
                    <p:cNvPr id="3" name="Image 2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BBE4453E-D8E3-3440-A338-B7B004AC5091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2"/>
                    <a:srcRect l="5224"/>
                    <a:stretch/>
                  </p:blipFill>
                  <p:spPr>
                    <a:xfrm>
                      <a:off x="5124734" y="102718"/>
                      <a:ext cx="4005587" cy="1346964"/>
                    </a:xfrm>
                    <a:prstGeom prst="rect">
                      <a:avLst/>
                    </a:prstGeom>
                  </p:spPr>
                </p:pic>
                <p:grpSp>
                  <p:nvGrpSpPr>
                    <p:cNvPr id="351" name="Groupe 350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7E401379-CA22-9942-B604-B4845A481482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6064772" y="1351043"/>
                      <a:ext cx="815417" cy="815098"/>
                      <a:chOff x="5311870" y="1513661"/>
                      <a:chExt cx="815417" cy="815098"/>
                    </a:xfrm>
                  </p:grpSpPr>
                  <p:sp>
                    <p:nvSpPr>
                      <p:cNvPr id="353" name="Parenthèse ouvrante 352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74D791DA-BF6F-F042-9483-D0C8464BCE7D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5645941" y="1711337"/>
                        <a:ext cx="80151" cy="668999"/>
                      </a:xfrm>
                      <a:prstGeom prst="leftBracket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fr-FR"/>
                      </a:p>
                    </p:txBody>
                  </p:sp>
                  <p:sp>
                    <p:nvSpPr>
                      <p:cNvPr id="357" name="ZoneTexte 356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54FEF602-8771-3A4A-8163-572ED16F7FFE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5543181" y="2051760"/>
                        <a:ext cx="270251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fr-FR" sz="12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5</a:t>
                        </a:r>
                      </a:p>
                    </p:txBody>
                  </p:sp>
                  <p:grpSp>
                    <p:nvGrpSpPr>
                      <p:cNvPr id="358" name="Groupe 357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F3B4BB19-1D5A-1C49-B3C4-EAE264DA4122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5311870" y="1513661"/>
                        <a:ext cx="424903" cy="513209"/>
                        <a:chOff x="5311870" y="1513661"/>
                        <a:chExt cx="424903" cy="513209"/>
                      </a:xfrm>
                    </p:grpSpPr>
                    <p:grpSp>
                      <p:nvGrpSpPr>
                        <p:cNvPr id="365" name="Groupe 364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15C133B6-D83B-6243-BF3A-E6A592EFD057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5311870" y="1513661"/>
                          <a:ext cx="424903" cy="283349"/>
                          <a:chOff x="5311870" y="1513661"/>
                          <a:chExt cx="424903" cy="283349"/>
                        </a:xfrm>
                      </p:grpSpPr>
                      <p:sp>
                        <p:nvSpPr>
                          <p:cNvPr id="367" name="ZoneTexte 366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3FBEB893-2E02-1345-97A0-ED775B16E420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5311870" y="1513661"/>
                            <a:ext cx="231779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-</a:t>
                            </a:r>
                          </a:p>
                        </p:txBody>
                      </p:sp>
                      <p:sp>
                        <p:nvSpPr>
                          <p:cNvPr id="368" name="ZoneTexte 367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5A773B99-7BD9-134C-B336-C07F70046733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5475163" y="1520011"/>
                            <a:ext cx="261610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+</a:t>
                            </a:r>
                          </a:p>
                        </p:txBody>
                      </p:sp>
                      <p:sp>
                        <p:nvSpPr>
                          <p:cNvPr id="369" name="Parenthèse ouvrante 368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B2788B83-E95D-4245-8648-27FB10E613EA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 rot="16200000">
                            <a:off x="5481000" y="1606960"/>
                            <a:ext cx="72000" cy="270000"/>
                          </a:xfrm>
                          <a:prstGeom prst="leftBracket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fr-FR"/>
                          </a:p>
                        </p:txBody>
                      </p:sp>
                    </p:grpSp>
                    <p:sp>
                      <p:nvSpPr>
                        <p:cNvPr id="366" name="ZoneTexte 365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BF790632-4A60-5448-9F72-ECF772E8559F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312833" y="1765260"/>
                          <a:ext cx="416801" cy="26161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fr-FR" sz="1100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WT</a:t>
                          </a:r>
                        </a:p>
                      </p:txBody>
                    </p:sp>
                  </p:grpSp>
                  <p:grpSp>
                    <p:nvGrpSpPr>
                      <p:cNvPr id="359" name="Groupe 358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2D502CE8-4E63-4B46-A5B7-5BDA69772FC4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5581205" y="1520011"/>
                        <a:ext cx="546082" cy="506859"/>
                        <a:chOff x="5581205" y="1520011"/>
                        <a:chExt cx="546082" cy="506859"/>
                      </a:xfrm>
                    </p:grpSpPr>
                    <p:sp>
                      <p:nvSpPr>
                        <p:cNvPr id="360" name="ZoneTexte 359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5C78C7D4-4F7F-B149-958C-367B87BB5402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581205" y="1765260"/>
                          <a:ext cx="546082" cy="26161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fr-FR" sz="1100" b="1" i="1" dirty="0" err="1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perR</a:t>
                          </a:r>
                          <a:endParaRPr lang="fr-FR" sz="1100" b="1" i="1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grpSp>
                      <p:nvGrpSpPr>
                        <p:cNvPr id="361" name="Groupe 360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6E4D2695-B687-BA49-A83C-4D02798C832E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5651168" y="1520011"/>
                          <a:ext cx="411135" cy="276999"/>
                          <a:chOff x="5651168" y="1520011"/>
                          <a:chExt cx="411135" cy="276999"/>
                        </a:xfrm>
                      </p:grpSpPr>
                      <p:sp>
                        <p:nvSpPr>
                          <p:cNvPr id="362" name="ZoneTexte 361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F431CDAD-690E-014F-9FA5-E35788B423AE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5651168" y="1520011"/>
                            <a:ext cx="231779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-</a:t>
                            </a:r>
                          </a:p>
                        </p:txBody>
                      </p:sp>
                      <p:sp>
                        <p:nvSpPr>
                          <p:cNvPr id="363" name="ZoneTexte 362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4CEBFF33-8090-1E46-B604-E8162DFFAEB8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5800693" y="1520011"/>
                            <a:ext cx="261610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+</a:t>
                            </a:r>
                          </a:p>
                        </p:txBody>
                      </p:sp>
                      <p:sp>
                        <p:nvSpPr>
                          <p:cNvPr id="364" name="Parenthèse ouvrante 363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3A64621F-F7C9-7249-9AFF-6940A269AFDD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 rot="16200000">
                            <a:off x="5807043" y="1606960"/>
                            <a:ext cx="72000" cy="270000"/>
                          </a:xfrm>
                          <a:prstGeom prst="leftBracket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fr-FR"/>
                          </a:p>
                        </p:txBody>
                      </p:sp>
                    </p:grpSp>
                  </p:grpSp>
                </p:grpSp>
                <p:grpSp>
                  <p:nvGrpSpPr>
                    <p:cNvPr id="371" name="Groupe 370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90E0D8A9-B4D2-DA40-A03F-B40A38E40886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6817674" y="1353315"/>
                      <a:ext cx="815417" cy="815098"/>
                      <a:chOff x="5311870" y="1513661"/>
                      <a:chExt cx="815417" cy="815098"/>
                    </a:xfrm>
                  </p:grpSpPr>
                  <p:sp>
                    <p:nvSpPr>
                      <p:cNvPr id="372" name="Parenthèse ouvrante 371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10720984-4C5D-CC4D-921D-C6C5A7BDDBC8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5645941" y="1711337"/>
                        <a:ext cx="80151" cy="668999"/>
                      </a:xfrm>
                      <a:prstGeom prst="leftBracket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fr-FR"/>
                      </a:p>
                    </p:txBody>
                  </p:sp>
                  <p:sp>
                    <p:nvSpPr>
                      <p:cNvPr id="373" name="ZoneTexte 372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462A0193-3302-6A40-A178-4B5A79C10003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5543181" y="2051760"/>
                        <a:ext cx="270251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fr-FR" sz="12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9</a:t>
                        </a:r>
                      </a:p>
                    </p:txBody>
                  </p:sp>
                  <p:grpSp>
                    <p:nvGrpSpPr>
                      <p:cNvPr id="374" name="Groupe 373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C48E7496-853E-7D44-A7A5-9EB0A19F5FE1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5311870" y="1513661"/>
                        <a:ext cx="424903" cy="513209"/>
                        <a:chOff x="5311870" y="1513661"/>
                        <a:chExt cx="424903" cy="513209"/>
                      </a:xfrm>
                    </p:grpSpPr>
                    <p:grpSp>
                      <p:nvGrpSpPr>
                        <p:cNvPr id="381" name="Groupe 380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1189F51B-0783-C24E-BCB7-E33FB8EB5E86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5311870" y="1513661"/>
                          <a:ext cx="424903" cy="283349"/>
                          <a:chOff x="5311870" y="1513661"/>
                          <a:chExt cx="424903" cy="283349"/>
                        </a:xfrm>
                      </p:grpSpPr>
                      <p:sp>
                        <p:nvSpPr>
                          <p:cNvPr id="383" name="ZoneTexte 382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7F01FC78-D10A-C347-AFF4-C585AC955BD4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5311870" y="1513661"/>
                            <a:ext cx="231779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-</a:t>
                            </a:r>
                          </a:p>
                        </p:txBody>
                      </p:sp>
                      <p:sp>
                        <p:nvSpPr>
                          <p:cNvPr id="384" name="ZoneTexte 383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D77234C6-A696-634E-B7AA-3B523E0E7F8A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5475163" y="1520011"/>
                            <a:ext cx="261610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+</a:t>
                            </a:r>
                          </a:p>
                        </p:txBody>
                      </p:sp>
                      <p:sp>
                        <p:nvSpPr>
                          <p:cNvPr id="385" name="Parenthèse ouvrante 384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BC37FCB4-3A98-0F46-BAA0-A475DFF79579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 rot="16200000">
                            <a:off x="5481000" y="1606960"/>
                            <a:ext cx="72000" cy="270000"/>
                          </a:xfrm>
                          <a:prstGeom prst="leftBracket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fr-FR"/>
                          </a:p>
                        </p:txBody>
                      </p:sp>
                    </p:grpSp>
                    <p:sp>
                      <p:nvSpPr>
                        <p:cNvPr id="382" name="ZoneTexte 381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E4306407-1649-E44B-BE08-58244671AB72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312833" y="1765260"/>
                          <a:ext cx="416801" cy="26161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fr-FR" sz="1100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WT</a:t>
                          </a:r>
                        </a:p>
                      </p:txBody>
                    </p:sp>
                  </p:grpSp>
                  <p:grpSp>
                    <p:nvGrpSpPr>
                      <p:cNvPr id="375" name="Groupe 374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6ECA63C8-6063-4F4F-8835-5FE1B68FA61B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5581205" y="1520011"/>
                        <a:ext cx="546082" cy="506859"/>
                        <a:chOff x="5581205" y="1520011"/>
                        <a:chExt cx="546082" cy="506859"/>
                      </a:xfrm>
                    </p:grpSpPr>
                    <p:sp>
                      <p:nvSpPr>
                        <p:cNvPr id="376" name="ZoneTexte 375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08CA4931-909E-B044-B1C7-DF406E99D2BB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581205" y="1765260"/>
                          <a:ext cx="546082" cy="26161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fr-FR" sz="1100" b="1" i="1" dirty="0" err="1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perR</a:t>
                          </a:r>
                          <a:endParaRPr lang="fr-FR" sz="1100" b="1" i="1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grpSp>
                      <p:nvGrpSpPr>
                        <p:cNvPr id="377" name="Groupe 376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FD67813D-30FB-5F47-A4F3-6693C8E22595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5651168" y="1520011"/>
                          <a:ext cx="411135" cy="276999"/>
                          <a:chOff x="5651168" y="1520011"/>
                          <a:chExt cx="411135" cy="276999"/>
                        </a:xfrm>
                      </p:grpSpPr>
                      <p:sp>
                        <p:nvSpPr>
                          <p:cNvPr id="378" name="ZoneTexte 377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BB0014C1-B5B9-B545-BDB6-1AE18F137213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5651168" y="1520011"/>
                            <a:ext cx="231779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-</a:t>
                            </a:r>
                          </a:p>
                        </p:txBody>
                      </p:sp>
                      <p:sp>
                        <p:nvSpPr>
                          <p:cNvPr id="379" name="ZoneTexte 378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0388BC77-D39F-6D46-AC57-250CD52F225B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5800693" y="1520011"/>
                            <a:ext cx="261610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+</a:t>
                            </a:r>
                          </a:p>
                        </p:txBody>
                      </p:sp>
                      <p:sp>
                        <p:nvSpPr>
                          <p:cNvPr id="380" name="Parenthèse ouvrante 379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5C5AE48A-53EF-234B-95FD-CB683F79F8A8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 rot="16200000">
                            <a:off x="5807043" y="1606960"/>
                            <a:ext cx="72000" cy="270000"/>
                          </a:xfrm>
                          <a:prstGeom prst="leftBracket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fr-FR"/>
                          </a:p>
                        </p:txBody>
                      </p:sp>
                    </p:grpSp>
                  </p:grpSp>
                </p:grpSp>
                <p:grpSp>
                  <p:nvGrpSpPr>
                    <p:cNvPr id="386" name="Groupe 385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5B9006F8-F264-5441-B09B-885F8677829B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7591049" y="1348763"/>
                      <a:ext cx="815417" cy="815098"/>
                      <a:chOff x="5311870" y="1513661"/>
                      <a:chExt cx="815417" cy="815098"/>
                    </a:xfrm>
                  </p:grpSpPr>
                  <p:sp>
                    <p:nvSpPr>
                      <p:cNvPr id="387" name="Parenthèse ouvrante 386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73620FB9-9F82-7443-AACE-D2BCCE36CD92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5645941" y="1711337"/>
                        <a:ext cx="80151" cy="668999"/>
                      </a:xfrm>
                      <a:prstGeom prst="leftBracket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fr-FR"/>
                      </a:p>
                    </p:txBody>
                  </p:sp>
                  <p:sp>
                    <p:nvSpPr>
                      <p:cNvPr id="388" name="ZoneTexte 387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DF947232-638C-3944-AB42-2A79F2B61F35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5543181" y="2051760"/>
                        <a:ext cx="346120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fr-FR" sz="12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1</a:t>
                        </a:r>
                      </a:p>
                    </p:txBody>
                  </p:sp>
                  <p:grpSp>
                    <p:nvGrpSpPr>
                      <p:cNvPr id="389" name="Groupe 388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E0FAB90D-8678-6F47-AFC9-6D82F27B946B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5311870" y="1513661"/>
                        <a:ext cx="424903" cy="513209"/>
                        <a:chOff x="5311870" y="1513661"/>
                        <a:chExt cx="424903" cy="513209"/>
                      </a:xfrm>
                    </p:grpSpPr>
                    <p:grpSp>
                      <p:nvGrpSpPr>
                        <p:cNvPr id="396" name="Groupe 395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0F5AC3D8-DC41-2C4A-A8EA-C62BC20A1DB0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5311870" y="1513661"/>
                          <a:ext cx="424903" cy="283349"/>
                          <a:chOff x="5311870" y="1513661"/>
                          <a:chExt cx="424903" cy="283349"/>
                        </a:xfrm>
                      </p:grpSpPr>
                      <p:sp>
                        <p:nvSpPr>
                          <p:cNvPr id="398" name="ZoneTexte 397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A7F6FBD6-CF2D-E540-910D-C9F2211EE500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5311870" y="1513661"/>
                            <a:ext cx="231779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-</a:t>
                            </a:r>
                          </a:p>
                        </p:txBody>
                      </p:sp>
                      <p:sp>
                        <p:nvSpPr>
                          <p:cNvPr id="399" name="ZoneTexte 398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7BDCBE2B-81DB-8B4D-966D-AD4BD67C8A9B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5475163" y="1520011"/>
                            <a:ext cx="261610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+</a:t>
                            </a:r>
                          </a:p>
                        </p:txBody>
                      </p:sp>
                      <p:sp>
                        <p:nvSpPr>
                          <p:cNvPr id="400" name="Parenthèse ouvrante 399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A0803F54-7C77-9E44-B1B1-49DBAAB44108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 rot="16200000">
                            <a:off x="5481000" y="1606960"/>
                            <a:ext cx="72000" cy="270000"/>
                          </a:xfrm>
                          <a:prstGeom prst="leftBracket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fr-FR"/>
                          </a:p>
                        </p:txBody>
                      </p:sp>
                    </p:grpSp>
                    <p:sp>
                      <p:nvSpPr>
                        <p:cNvPr id="397" name="ZoneTexte 396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41D6591B-E6A5-BD49-9551-CAD8259FF478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312833" y="1765260"/>
                          <a:ext cx="416801" cy="26161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fr-FR" sz="1100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WT</a:t>
                          </a:r>
                        </a:p>
                      </p:txBody>
                    </p:sp>
                  </p:grpSp>
                  <p:grpSp>
                    <p:nvGrpSpPr>
                      <p:cNvPr id="390" name="Groupe 389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AE436897-F797-BC49-BC03-48EF5DFD69CD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5581205" y="1520011"/>
                        <a:ext cx="546082" cy="506859"/>
                        <a:chOff x="5581205" y="1520011"/>
                        <a:chExt cx="546082" cy="506859"/>
                      </a:xfrm>
                    </p:grpSpPr>
                    <p:sp>
                      <p:nvSpPr>
                        <p:cNvPr id="391" name="ZoneTexte 390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ED07A5DB-D51D-6845-85BE-A9C1908B8133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581205" y="1765260"/>
                          <a:ext cx="546082" cy="26161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fr-FR" sz="1100" b="1" i="1" dirty="0" err="1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perR</a:t>
                          </a:r>
                          <a:endParaRPr lang="fr-FR" sz="1100" b="1" i="1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grpSp>
                      <p:nvGrpSpPr>
                        <p:cNvPr id="392" name="Groupe 391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05A47391-69F2-7E4F-BC96-37FB677293CC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5651168" y="1520011"/>
                          <a:ext cx="411135" cy="276999"/>
                          <a:chOff x="5651168" y="1520011"/>
                          <a:chExt cx="411135" cy="276999"/>
                        </a:xfrm>
                      </p:grpSpPr>
                      <p:sp>
                        <p:nvSpPr>
                          <p:cNvPr id="393" name="ZoneTexte 392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D711EB94-9105-B24E-9A4D-62AF374C8395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5651168" y="1520011"/>
                            <a:ext cx="231779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-</a:t>
                            </a:r>
                          </a:p>
                        </p:txBody>
                      </p:sp>
                      <p:sp>
                        <p:nvSpPr>
                          <p:cNvPr id="394" name="ZoneTexte 393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F6EB2BDE-44F8-EA4E-B489-52C2BAB2778D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5800693" y="1520011"/>
                            <a:ext cx="261610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+</a:t>
                            </a:r>
                          </a:p>
                        </p:txBody>
                      </p:sp>
                      <p:sp>
                        <p:nvSpPr>
                          <p:cNvPr id="395" name="Parenthèse ouvrante 394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7CC2FAE9-1B77-3E4B-816A-C6B0E1FD25D5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 rot="16200000">
                            <a:off x="5807043" y="1606960"/>
                            <a:ext cx="72000" cy="270000"/>
                          </a:xfrm>
                          <a:prstGeom prst="leftBracket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fr-FR"/>
                          </a:p>
                        </p:txBody>
                      </p:sp>
                    </p:grpSp>
                  </p:grpSp>
                </p:grpSp>
                <p:grpSp>
                  <p:nvGrpSpPr>
                    <p:cNvPr id="401" name="Groupe 400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51E0A765-603A-F84A-9882-05980DBC1131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337127" y="1351035"/>
                      <a:ext cx="815417" cy="815098"/>
                      <a:chOff x="5311870" y="1513661"/>
                      <a:chExt cx="815417" cy="815098"/>
                    </a:xfrm>
                  </p:grpSpPr>
                  <p:sp>
                    <p:nvSpPr>
                      <p:cNvPr id="402" name="Parenthèse ouvrante 401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75525E4A-E088-D647-943E-33B47915B341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5645941" y="1711337"/>
                        <a:ext cx="80151" cy="668999"/>
                      </a:xfrm>
                      <a:prstGeom prst="leftBracket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fr-FR"/>
                      </a:p>
                    </p:txBody>
                  </p:sp>
                  <p:sp>
                    <p:nvSpPr>
                      <p:cNvPr id="403" name="ZoneTexte 402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8FA92FE3-5CB6-144A-A5CE-5DBAAA81720B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5543181" y="2051760"/>
                        <a:ext cx="354584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fr-FR" sz="12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2</a:t>
                        </a:r>
                      </a:p>
                    </p:txBody>
                  </p:sp>
                  <p:grpSp>
                    <p:nvGrpSpPr>
                      <p:cNvPr id="404" name="Groupe 403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EDC904D5-68B5-F04A-8986-56DC4308A2B7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5311870" y="1513661"/>
                        <a:ext cx="424903" cy="513209"/>
                        <a:chOff x="5311870" y="1513661"/>
                        <a:chExt cx="424903" cy="513209"/>
                      </a:xfrm>
                    </p:grpSpPr>
                    <p:grpSp>
                      <p:nvGrpSpPr>
                        <p:cNvPr id="411" name="Groupe 410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E654265C-B5FF-314B-919B-785C5ACA0C9F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5311870" y="1513661"/>
                          <a:ext cx="424903" cy="283349"/>
                          <a:chOff x="5311870" y="1513661"/>
                          <a:chExt cx="424903" cy="283349"/>
                        </a:xfrm>
                      </p:grpSpPr>
                      <p:sp>
                        <p:nvSpPr>
                          <p:cNvPr id="413" name="ZoneTexte 412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6641297D-3BBB-3C46-B824-BAE0FE239B06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5311870" y="1513661"/>
                            <a:ext cx="231779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-</a:t>
                            </a:r>
                          </a:p>
                        </p:txBody>
                      </p:sp>
                      <p:sp>
                        <p:nvSpPr>
                          <p:cNvPr id="414" name="ZoneTexte 413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B3A885B9-8EED-C34C-A867-562A2ACCA753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5475163" y="1520011"/>
                            <a:ext cx="261610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+</a:t>
                            </a:r>
                          </a:p>
                        </p:txBody>
                      </p:sp>
                      <p:sp>
                        <p:nvSpPr>
                          <p:cNvPr id="415" name="Parenthèse ouvrante 414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60C5C7EC-0E88-864A-B9E0-4E3C76F23882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 rot="16200000">
                            <a:off x="5481000" y="1606960"/>
                            <a:ext cx="72000" cy="270000"/>
                          </a:xfrm>
                          <a:prstGeom prst="leftBracket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fr-FR"/>
                          </a:p>
                        </p:txBody>
                      </p:sp>
                    </p:grpSp>
                    <p:sp>
                      <p:nvSpPr>
                        <p:cNvPr id="412" name="ZoneTexte 411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EEDFF7DC-D6E7-1845-B2AE-9CA8A8DD0449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312833" y="1765260"/>
                          <a:ext cx="416801" cy="26161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fr-FR" sz="1100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WT</a:t>
                          </a:r>
                        </a:p>
                      </p:txBody>
                    </p:sp>
                  </p:grpSp>
                  <p:grpSp>
                    <p:nvGrpSpPr>
                      <p:cNvPr id="405" name="Groupe 404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C44BCFC0-C2AC-6E4C-9D2C-BD065E817BCE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5581205" y="1520011"/>
                        <a:ext cx="546082" cy="506859"/>
                        <a:chOff x="5581205" y="1520011"/>
                        <a:chExt cx="546082" cy="506859"/>
                      </a:xfrm>
                    </p:grpSpPr>
                    <p:sp>
                      <p:nvSpPr>
                        <p:cNvPr id="406" name="ZoneTexte 405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674EF05C-8E18-194B-8E54-73F77AC60257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581205" y="1765260"/>
                          <a:ext cx="546082" cy="26161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fr-FR" sz="1100" b="1" i="1" dirty="0" err="1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perR</a:t>
                          </a:r>
                          <a:endParaRPr lang="fr-FR" sz="1100" b="1" i="1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grpSp>
                      <p:nvGrpSpPr>
                        <p:cNvPr id="407" name="Groupe 406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A81B6D24-4A77-8548-9799-D9C19FF88930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5651168" y="1520011"/>
                          <a:ext cx="411135" cy="276999"/>
                          <a:chOff x="5651168" y="1520011"/>
                          <a:chExt cx="411135" cy="276999"/>
                        </a:xfrm>
                      </p:grpSpPr>
                      <p:sp>
                        <p:nvSpPr>
                          <p:cNvPr id="408" name="ZoneTexte 407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66F94FA6-2173-C94C-9FE0-76015766CA5B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5651168" y="1520011"/>
                            <a:ext cx="231779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-</a:t>
                            </a:r>
                          </a:p>
                        </p:txBody>
                      </p:sp>
                      <p:sp>
                        <p:nvSpPr>
                          <p:cNvPr id="409" name="ZoneTexte 408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0DC070B2-89C9-C843-940D-801287CF2E8D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5800693" y="1520011"/>
                            <a:ext cx="261610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+</a:t>
                            </a:r>
                          </a:p>
                        </p:txBody>
                      </p:sp>
                      <p:sp>
                        <p:nvSpPr>
                          <p:cNvPr id="410" name="Parenthèse ouvrante 409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E3876A56-98FD-594A-964E-1A4434F8D4DC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 rot="16200000">
                            <a:off x="5807043" y="1606960"/>
                            <a:ext cx="72000" cy="270000"/>
                          </a:xfrm>
                          <a:prstGeom prst="leftBracket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fr-FR"/>
                          </a:p>
                        </p:txBody>
                      </p:sp>
                    </p:grpSp>
                  </p:grpSp>
                </p:grpSp>
                <p:sp>
                  <p:nvSpPr>
                    <p:cNvPr id="416" name="ZoneTexte 415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B15D23C6-1D3B-1E4F-BA3F-612A8B311A99}"/>
                        </a:ext>
                      </a:extLst>
                    </p:cNvPr>
                    <p:cNvSpPr txBox="1"/>
                    <p:nvPr/>
                  </p:nvSpPr>
                  <p:spPr>
                    <a:xfrm rot="16200000">
                      <a:off x="4265605" y="637701"/>
                      <a:ext cx="1383712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fr-FR" sz="12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ld</a:t>
                      </a:r>
                      <a:r>
                        <a:rPr lang="fr-FR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FR" sz="12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richment</a:t>
                      </a:r>
                      <a:endParaRPr lang="fr-FR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257" name="ZoneTexte 256">
                    <a:extLst>
                      <a:ext uri="{FF2B5EF4-FFF2-40B4-BE49-F238E27FC236}">
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20288103-7D1B-5C42-9A75-698DCE1E9BFC}"/>
                      </a:ext>
                    </a:extLst>
                  </p:cNvPr>
                  <p:cNvSpPr txBox="1"/>
                  <p:nvPr/>
                </p:nvSpPr>
                <p:spPr>
                  <a:xfrm>
                    <a:off x="8982048" y="1385714"/>
                    <a:ext cx="718466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10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ntibody</a:t>
                    </a:r>
                    <a:endParaRPr lang="fr-FR" sz="10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sp>
            <p:nvSpPr>
              <p:cNvPr id="262" name="ZoneTexte 261"/>
              <p:cNvSpPr txBox="1"/>
              <p:nvPr/>
            </p:nvSpPr>
            <p:spPr>
              <a:xfrm>
                <a:off x="355443" y="107581"/>
                <a:ext cx="166712" cy="276999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fr-FR" b="1" dirty="0" smtClean="0">
                    <a:latin typeface="Arial"/>
                    <a:cs typeface="Arial"/>
                  </a:rPr>
                  <a:t>A</a:t>
                </a:r>
                <a:endParaRPr lang="fr-FR" b="1" dirty="0">
                  <a:latin typeface="Arial"/>
                  <a:cs typeface="Arial"/>
                </a:endParaRPr>
              </a:p>
            </p:txBody>
          </p:sp>
        </p:grpSp>
        <p:grpSp>
          <p:nvGrpSpPr>
            <p:cNvPr id="267" name="Grouper 266"/>
            <p:cNvGrpSpPr/>
            <p:nvPr/>
          </p:nvGrpSpPr>
          <p:grpSpPr>
            <a:xfrm>
              <a:off x="355449" y="2187119"/>
              <a:ext cx="9384030" cy="2396705"/>
              <a:chOff x="355449" y="2187119"/>
              <a:chExt cx="9384030" cy="2396705"/>
            </a:xfrm>
          </p:grpSpPr>
          <p:grpSp>
            <p:nvGrpSpPr>
              <p:cNvPr id="41" name="Groupe 40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F3C4289C-2A24-7E46-BD75-9D8631ECD9ED}"/>
                  </a:ext>
                </a:extLst>
              </p:cNvPr>
              <p:cNvGrpSpPr/>
              <p:nvPr/>
            </p:nvGrpSpPr>
            <p:grpSpPr>
              <a:xfrm>
                <a:off x="747374" y="2187341"/>
                <a:ext cx="8992105" cy="2396483"/>
                <a:chOff x="747374" y="2187341"/>
                <a:chExt cx="8992105" cy="2396483"/>
              </a:xfrm>
            </p:grpSpPr>
            <p:grpSp>
              <p:nvGrpSpPr>
                <p:cNvPr id="22" name="Groupe 21">
                  <a:extLst>
                    <a:ext uri="{FF2B5EF4-FFF2-40B4-BE49-F238E27FC236}">
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48415DAC-D0E4-E549-BB87-C23B3F784AE1}"/>
                    </a:ext>
                  </a:extLst>
                </p:cNvPr>
                <p:cNvGrpSpPr/>
                <p:nvPr/>
              </p:nvGrpSpPr>
              <p:grpSpPr>
                <a:xfrm>
                  <a:off x="747374" y="2872002"/>
                  <a:ext cx="3509331" cy="813145"/>
                  <a:chOff x="747374" y="2872002"/>
                  <a:chExt cx="3509331" cy="813145"/>
                </a:xfrm>
              </p:grpSpPr>
              <p:grpSp>
                <p:nvGrpSpPr>
                  <p:cNvPr id="5" name="Grouper 4"/>
                  <p:cNvGrpSpPr/>
                  <p:nvPr/>
                </p:nvGrpSpPr>
                <p:grpSpPr>
                  <a:xfrm>
                    <a:off x="747374" y="2872002"/>
                    <a:ext cx="3509331" cy="813145"/>
                    <a:chOff x="543839" y="6144291"/>
                    <a:chExt cx="3509331" cy="813145"/>
                  </a:xfrm>
                </p:grpSpPr>
                <p:grpSp>
                  <p:nvGrpSpPr>
                    <p:cNvPr id="6" name="Grouper 145"/>
                    <p:cNvGrpSpPr/>
                    <p:nvPr/>
                  </p:nvGrpSpPr>
                  <p:grpSpPr>
                    <a:xfrm>
                      <a:off x="3058174" y="6144291"/>
                      <a:ext cx="994996" cy="446075"/>
                      <a:chOff x="4863444" y="5314880"/>
                      <a:chExt cx="1356182" cy="446075"/>
                    </a:xfrm>
                  </p:grpSpPr>
                  <p:sp>
                    <p:nvSpPr>
                      <p:cNvPr id="24" name="TextBox 67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7CECF81C-4386-F241-AE37-8FD6CDA61A3B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863444" y="5514734"/>
                        <a:ext cx="1356182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10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LIMLP_02795</a:t>
                        </a:r>
                      </a:p>
                    </p:txBody>
                  </p:sp>
                  <p:sp>
                    <p:nvSpPr>
                      <p:cNvPr id="25" name="TextBox 71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45BD3961-9BDE-8C40-BBC2-375CF046369D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5136845" y="5314880"/>
                        <a:ext cx="809384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1000" b="1" i="1" dirty="0" err="1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ccp</a:t>
                        </a:r>
                        <a:endParaRPr lang="en-US" sz="1000" b="1" i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sp>
                  <p:nvSpPr>
                    <p:cNvPr id="7" name="TextBox 68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4B7D315E-F2D5-9C4B-8441-50D313558EA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013680" y="6344145"/>
                      <a:ext cx="1016105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MLP_02790</a:t>
                      </a:r>
                    </a:p>
                  </p:txBody>
                </p:sp>
                <p:grpSp>
                  <p:nvGrpSpPr>
                    <p:cNvPr id="8" name="Grouper 143"/>
                    <p:cNvGrpSpPr/>
                    <p:nvPr/>
                  </p:nvGrpSpPr>
                  <p:grpSpPr>
                    <a:xfrm>
                      <a:off x="543839" y="6556932"/>
                      <a:ext cx="3466176" cy="400504"/>
                      <a:chOff x="-1029117" y="5435251"/>
                      <a:chExt cx="7471703" cy="541474"/>
                    </a:xfrm>
                  </p:grpSpPr>
                  <p:cxnSp>
                    <p:nvCxnSpPr>
                      <p:cNvPr id="9" name="Straight Connector 61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4A316822-310C-254A-8CB9-6635B065EFC7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-1029117" y="5556942"/>
                        <a:ext cx="7343999" cy="10513"/>
                      </a:xfrm>
                      <a:prstGeom prst="line">
                        <a:avLst/>
                      </a:prstGeom>
                      <a:ln w="12700" cap="flat" cmpd="sng" algn="ctr">
                        <a:solidFill>
                          <a:schemeClr val="dk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  <p:style>
                      <a:lnRef idx="3">
                        <a:schemeClr val="dk1"/>
                      </a:lnRef>
                      <a:fillRef idx="0">
                        <a:schemeClr val="dk1"/>
                      </a:fillRef>
                      <a:effectRef idx="2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0" name="Down Arrow 64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B134C853-6CE4-6A41-A951-24EEBBD252F2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 flipH="1">
                        <a:off x="3181784" y="4625708"/>
                        <a:ext cx="243355" cy="1862442"/>
                      </a:xfrm>
                      <a:prstGeom prst="downArrow">
                        <a:avLst/>
                      </a:prstGeom>
                      <a:solidFill>
                        <a:schemeClr val="tx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vert="vert270" rtlCol="0" anchor="ctr"/>
                      <a:lstStyle/>
                      <a:p>
                        <a:pPr algn="ctr"/>
                        <a:endParaRPr lang="en-US" sz="10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1" name="Down Arrow 64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AA103C19-C716-0543-A1B0-B338315416E3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 flipH="1">
                        <a:off x="5389687" y="4625708"/>
                        <a:ext cx="243355" cy="1862442"/>
                      </a:xfrm>
                      <a:prstGeom prst="downArrow">
                        <a:avLst/>
                      </a:prstGeom>
                      <a:solidFill>
                        <a:schemeClr val="tx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vert="vert270" rtlCol="0" anchor="ctr"/>
                      <a:lstStyle/>
                      <a:p>
                        <a:pPr algn="ctr"/>
                        <a:endParaRPr lang="en-US" sz="1000" b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grpSp>
                    <p:nvGrpSpPr>
                      <p:cNvPr id="13" name="Groupe 24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7EE20ED2-27A4-6549-A387-FD2DAE6633BC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419361" y="5722447"/>
                        <a:ext cx="723774" cy="252638"/>
                        <a:chOff x="4982605" y="1913413"/>
                        <a:chExt cx="723774" cy="252638"/>
                      </a:xfrm>
                    </p:grpSpPr>
                    <p:sp>
                      <p:nvSpPr>
                        <p:cNvPr id="20" name="TextBox 25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CD6EF17C-333C-6E49-8D98-83CEB8B6CE06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4982605" y="1957991"/>
                          <a:ext cx="723774" cy="20806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lIns="0" tIns="0" rIns="0" bIns="0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sz="1000" b="1" dirty="0">
                              <a:solidFill>
                                <a:srgbClr val="000000"/>
                              </a:solidFill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BC3</a:t>
                          </a:r>
                        </a:p>
                      </p:txBody>
                    </p:sp>
                    <p:cxnSp>
                      <p:nvCxnSpPr>
                        <p:cNvPr id="21" name="Connecteur droit avec flèche 20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4F0F9F31-6318-344B-95DB-BFE0FE0F9EE3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5186885" y="1913413"/>
                          <a:ext cx="270000" cy="0"/>
                        </a:xfrm>
                        <a:prstGeom prst="straightConnector1">
                          <a:avLst/>
                        </a:prstGeom>
                        <a:ln w="1905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  <p:grpSp>
                    <p:nvGrpSpPr>
                      <p:cNvPr id="14" name="Groupe 24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7EE20ED2-27A4-6549-A387-FD2DAE6633BC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660223" y="5722447"/>
                        <a:ext cx="613146" cy="252637"/>
                        <a:chOff x="5144004" y="1913413"/>
                        <a:chExt cx="613146" cy="252637"/>
                      </a:xfrm>
                    </p:grpSpPr>
                    <p:sp>
                      <p:nvSpPr>
                        <p:cNvPr id="18" name="TextBox 25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CD6EF17C-333C-6E49-8D98-83CEB8B6CE06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144004" y="1957990"/>
                          <a:ext cx="613146" cy="20806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lIns="0" tIns="0" rIns="0" bIns="0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sz="1000" b="1" dirty="0">
                              <a:solidFill>
                                <a:srgbClr val="000000"/>
                              </a:solidFill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BC4</a:t>
                          </a:r>
                        </a:p>
                      </p:txBody>
                    </p:sp>
                    <p:cxnSp>
                      <p:nvCxnSpPr>
                        <p:cNvPr id="19" name="Connecteur droit avec flèche 18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4F0F9F31-6318-344B-95DB-BFE0FE0F9EE3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5186885" y="1913413"/>
                          <a:ext cx="540000" cy="0"/>
                        </a:xfrm>
                        <a:prstGeom prst="straightConnector1">
                          <a:avLst/>
                        </a:prstGeom>
                        <a:ln w="1905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  <p:grpSp>
                    <p:nvGrpSpPr>
                      <p:cNvPr id="15" name="Groupe 24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7EE20ED2-27A4-6549-A387-FD2DAE6633BC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3152909" y="5722447"/>
                        <a:ext cx="2473587" cy="254278"/>
                        <a:chOff x="4959376" y="1976913"/>
                        <a:chExt cx="2473587" cy="254278"/>
                      </a:xfrm>
                    </p:grpSpPr>
                    <p:sp>
                      <p:nvSpPr>
                        <p:cNvPr id="16" name="TextBox 25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CD6EF17C-333C-6E49-8D98-83CEB8B6CE06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4959376" y="2019859"/>
                          <a:ext cx="730500" cy="2113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lIns="0" tIns="0" rIns="0" bIns="0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sz="1000" b="1" dirty="0">
                              <a:solidFill>
                                <a:srgbClr val="000000"/>
                              </a:solidFill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BC5</a:t>
                          </a:r>
                        </a:p>
                      </p:txBody>
                    </p:sp>
                    <p:cxnSp>
                      <p:nvCxnSpPr>
                        <p:cNvPr id="17" name="Connecteur droit avec flèche 16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4F0F9F31-6318-344B-95DB-BFE0FE0F9EE3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5186885" y="1976913"/>
                          <a:ext cx="269998" cy="0"/>
                        </a:xfrm>
                        <a:prstGeom prst="straightConnector1">
                          <a:avLst/>
                        </a:prstGeom>
                        <a:ln w="1905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417" name="TextBox 25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E69B6046-493F-3549-8A7B-100FF35DE052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6702463" y="2019859"/>
                          <a:ext cx="730500" cy="2113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lIns="0" tIns="0" rIns="0" bIns="0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sz="1000" b="1" dirty="0">
                              <a:solidFill>
                                <a:srgbClr val="000000"/>
                              </a:solidFill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BC7</a:t>
                          </a:r>
                        </a:p>
                      </p:txBody>
                    </p:sp>
                    <p:cxnSp>
                      <p:nvCxnSpPr>
                        <p:cNvPr id="418" name="Connecteur droit avec flèche 417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2FCE9C94-6F21-7C4C-A813-3D2838306006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6929972" y="1976914"/>
                          <a:ext cx="269998" cy="0"/>
                        </a:xfrm>
                        <a:prstGeom prst="straightConnector1">
                          <a:avLst/>
                        </a:prstGeom>
                        <a:ln w="1905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</p:grpSp>
              </p:grpSp>
              <p:sp>
                <p:nvSpPr>
                  <p:cNvPr id="251" name="TextBox 25">
                    <a:extLst>
                      <a:ext uri="{FF2B5EF4-FFF2-40B4-BE49-F238E27FC236}">
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7ED05FAA-B84E-9A46-81A1-6AF8EF190DD6}"/>
                      </a:ext>
                    </a:extLst>
                  </p:cNvPr>
                  <p:cNvSpPr txBox="1"/>
                  <p:nvPr/>
                </p:nvSpPr>
                <p:spPr>
                  <a:xfrm>
                    <a:off x="3153148" y="3227174"/>
                    <a:ext cx="224170" cy="123111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b="1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78</a:t>
                    </a:r>
                  </a:p>
                </p:txBody>
              </p:sp>
            </p:grpSp>
            <p:grpSp>
              <p:nvGrpSpPr>
                <p:cNvPr id="37" name="Groupe 36">
                  <a:extLst>
                    <a:ext uri="{FF2B5EF4-FFF2-40B4-BE49-F238E27FC236}">
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263763DD-BC7A-714D-8100-C0496A8B42F3}"/>
                    </a:ext>
                  </a:extLst>
                </p:cNvPr>
                <p:cNvGrpSpPr/>
                <p:nvPr/>
              </p:nvGrpSpPr>
              <p:grpSpPr>
                <a:xfrm>
                  <a:off x="4808664" y="2187341"/>
                  <a:ext cx="4930815" cy="2396483"/>
                  <a:chOff x="4808664" y="2187341"/>
                  <a:chExt cx="4930815" cy="2396483"/>
                </a:xfrm>
              </p:grpSpPr>
              <p:grpSp>
                <p:nvGrpSpPr>
                  <p:cNvPr id="153" name="Groupe 152">
                    <a:extLst>
                      <a:ext uri="{FF2B5EF4-FFF2-40B4-BE49-F238E27FC236}">
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8FA7D994-FAC2-A346-A354-A7AE21D888D3}"/>
                      </a:ext>
                    </a:extLst>
                  </p:cNvPr>
                  <p:cNvGrpSpPr/>
                  <p:nvPr/>
                </p:nvGrpSpPr>
                <p:grpSpPr>
                  <a:xfrm>
                    <a:off x="4808664" y="2187341"/>
                    <a:ext cx="4358883" cy="2396483"/>
                    <a:chOff x="4818961" y="2212869"/>
                    <a:chExt cx="4358883" cy="2396483"/>
                  </a:xfrm>
                </p:grpSpPr>
                <p:pic>
                  <p:nvPicPr>
                    <p:cNvPr id="136" name="Image 135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D2D757E8-2136-784B-B672-0BC27673499A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3"/>
                    <a:srcRect l="5472"/>
                    <a:stretch/>
                  </p:blipFill>
                  <p:spPr>
                    <a:xfrm>
                      <a:off x="5075692" y="2212869"/>
                      <a:ext cx="4102152" cy="1690554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419" name="ZoneTexte 418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5B82B591-1674-1845-AFE9-4CF207130607}"/>
                        </a:ext>
                      </a:extLst>
                    </p:cNvPr>
                    <p:cNvSpPr txBox="1"/>
                    <p:nvPr/>
                  </p:nvSpPr>
                  <p:spPr>
                    <a:xfrm rot="16200000">
                      <a:off x="4265605" y="2919647"/>
                      <a:ext cx="1383712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fr-FR" sz="12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ld</a:t>
                      </a:r>
                      <a:r>
                        <a:rPr lang="fr-FR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FR" sz="12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richment</a:t>
                      </a:r>
                      <a:endParaRPr lang="fr-FR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grpSp>
                  <p:nvGrpSpPr>
                    <p:cNvPr id="148" name="Groupe 147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E5C8E3F0-401E-4847-AF69-8E88D8ACFA49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5327972" y="3791232"/>
                      <a:ext cx="912245" cy="815098"/>
                      <a:chOff x="5368916" y="4159724"/>
                      <a:chExt cx="912245" cy="815098"/>
                    </a:xfrm>
                  </p:grpSpPr>
                  <p:sp>
                    <p:nvSpPr>
                      <p:cNvPr id="27" name="Parenthèse ouvrante 26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93A3E82E-4844-EC4B-9BA8-645CCA6865E0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5775772" y="4258172"/>
                        <a:ext cx="58640" cy="845946"/>
                      </a:xfrm>
                      <a:prstGeom prst="leftBracket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fr-FR"/>
                      </a:p>
                    </p:txBody>
                  </p:sp>
                  <p:sp>
                    <p:nvSpPr>
                      <p:cNvPr id="28" name="ZoneTexte 27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BB379FED-2250-5A49-8491-E0888C57F494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5569121" y="4697823"/>
                        <a:ext cx="490840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fr-FR" sz="12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BC3</a:t>
                        </a:r>
                      </a:p>
                    </p:txBody>
                  </p:sp>
                  <p:grpSp>
                    <p:nvGrpSpPr>
                      <p:cNvPr id="147" name="Groupe 146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03006391-F9F1-C04E-A693-1AC11AEBFD3F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5735079" y="4166074"/>
                        <a:ext cx="546082" cy="506859"/>
                        <a:chOff x="5735079" y="4166074"/>
                        <a:chExt cx="546082" cy="506859"/>
                      </a:xfrm>
                    </p:grpSpPr>
                    <p:sp>
                      <p:nvSpPr>
                        <p:cNvPr id="32" name="ZoneTexte 31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3E5D07DE-750F-1C49-A023-381F4B9464A0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735079" y="4411323"/>
                          <a:ext cx="546082" cy="26161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fr-FR" sz="1100" b="1" i="1" dirty="0" err="1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perR</a:t>
                          </a:r>
                          <a:endParaRPr lang="fr-FR" sz="1100" b="1" i="1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grpSp>
                      <p:nvGrpSpPr>
                        <p:cNvPr id="144" name="Groupe 143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38A50E94-B8E4-1640-A9BE-71C8AC5811E5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5789763" y="4166074"/>
                          <a:ext cx="454881" cy="276999"/>
                          <a:chOff x="5789763" y="4166074"/>
                          <a:chExt cx="454881" cy="276999"/>
                        </a:xfrm>
                      </p:grpSpPr>
                      <p:sp>
                        <p:nvSpPr>
                          <p:cNvPr id="34" name="ZoneTexte 33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DEF0ADB6-14A9-504A-8674-7CC0D2D1B891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5789763" y="4166074"/>
                            <a:ext cx="231779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-</a:t>
                            </a:r>
                          </a:p>
                        </p:txBody>
                      </p:sp>
                      <p:sp>
                        <p:nvSpPr>
                          <p:cNvPr id="35" name="ZoneTexte 34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0098E67F-8005-0047-96F0-287A9E128219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5983034" y="4166074"/>
                            <a:ext cx="261610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+</a:t>
                            </a:r>
                          </a:p>
                        </p:txBody>
                      </p:sp>
                      <p:sp>
                        <p:nvSpPr>
                          <p:cNvPr id="36" name="Parenthèse ouvrante 35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B28519C1-2B29-2640-9859-73301AD2007E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 rot="16200000">
                            <a:off x="5969056" y="4196434"/>
                            <a:ext cx="72000" cy="383177"/>
                          </a:xfrm>
                          <a:prstGeom prst="leftBracket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fr-FR"/>
                          </a:p>
                        </p:txBody>
                      </p:sp>
                    </p:grpSp>
                  </p:grpSp>
                  <p:grpSp>
                    <p:nvGrpSpPr>
                      <p:cNvPr id="146" name="Groupe 145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F0E7981F-7DB9-394F-9C30-F292604A055D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5368916" y="4159724"/>
                        <a:ext cx="464067" cy="513209"/>
                        <a:chOff x="5368916" y="4159724"/>
                        <a:chExt cx="464067" cy="513209"/>
                      </a:xfrm>
                    </p:grpSpPr>
                    <p:sp>
                      <p:nvSpPr>
                        <p:cNvPr id="38" name="ZoneTexte 37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FDD64D3B-E5FF-9547-9DFC-F91E6FA42C04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383465" y="4411323"/>
                          <a:ext cx="416801" cy="26161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fr-FR" sz="1100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WT</a:t>
                          </a:r>
                        </a:p>
                      </p:txBody>
                    </p:sp>
                    <p:grpSp>
                      <p:nvGrpSpPr>
                        <p:cNvPr id="145" name="Groupe 144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85F16B7C-0370-F14C-BC72-D24F30914CB0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5368916" y="4159724"/>
                          <a:ext cx="464067" cy="283349"/>
                          <a:chOff x="5368916" y="4159724"/>
                          <a:chExt cx="464067" cy="283349"/>
                        </a:xfrm>
                      </p:grpSpPr>
                      <p:sp>
                        <p:nvSpPr>
                          <p:cNvPr id="39" name="ZoneTexte 38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847B1F25-D2D1-8C40-BB45-B4E35B190343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5368916" y="4159724"/>
                            <a:ext cx="231779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-</a:t>
                            </a:r>
                          </a:p>
                        </p:txBody>
                      </p:sp>
                      <p:sp>
                        <p:nvSpPr>
                          <p:cNvPr id="40" name="ZoneTexte 39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9310CDDA-AF85-4D4F-A44A-D3F7999A947C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5571373" y="4166074"/>
                            <a:ext cx="261610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+</a:t>
                            </a:r>
                          </a:p>
                        </p:txBody>
                      </p:sp>
                      <p:sp>
                        <p:nvSpPr>
                          <p:cNvPr id="420" name="Parenthèse ouvrante 419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E963A710-0846-F544-BCD6-45BA6E1DED75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 rot="16200000">
                            <a:off x="5558281" y="4197440"/>
                            <a:ext cx="72000" cy="383177"/>
                          </a:xfrm>
                          <a:prstGeom prst="leftBracket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fr-FR"/>
                          </a:p>
                        </p:txBody>
                      </p:sp>
                    </p:grpSp>
                  </p:grpSp>
                </p:grpSp>
                <p:grpSp>
                  <p:nvGrpSpPr>
                    <p:cNvPr id="421" name="Groupe 420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DA9FE9FD-E509-5841-94BD-7E0DC195D720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6303943" y="3792239"/>
                      <a:ext cx="912245" cy="815098"/>
                      <a:chOff x="5368916" y="4159724"/>
                      <a:chExt cx="912245" cy="815098"/>
                    </a:xfrm>
                  </p:grpSpPr>
                  <p:sp>
                    <p:nvSpPr>
                      <p:cNvPr id="422" name="Parenthèse ouvrante 421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5838EAF7-B72B-5F41-AAE3-0FE35EBBB893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5775772" y="4258172"/>
                        <a:ext cx="58640" cy="845946"/>
                      </a:xfrm>
                      <a:prstGeom prst="leftBracket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fr-FR"/>
                      </a:p>
                    </p:txBody>
                  </p:sp>
                  <p:sp>
                    <p:nvSpPr>
                      <p:cNvPr id="423" name="ZoneTexte 422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6EB178EA-B56E-EC4B-AEF5-BF713CFB1C63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5569121" y="4697823"/>
                        <a:ext cx="490840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fr-FR" sz="12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BC4</a:t>
                        </a:r>
                      </a:p>
                    </p:txBody>
                  </p:sp>
                  <p:grpSp>
                    <p:nvGrpSpPr>
                      <p:cNvPr id="424" name="Groupe 423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0F7859ED-F313-3549-8A4F-929123F74C3F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5735079" y="4166074"/>
                        <a:ext cx="546082" cy="506859"/>
                        <a:chOff x="5735079" y="4166074"/>
                        <a:chExt cx="546082" cy="506859"/>
                      </a:xfrm>
                    </p:grpSpPr>
                    <p:sp>
                      <p:nvSpPr>
                        <p:cNvPr id="431" name="ZoneTexte 430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3DB7250C-796B-6D45-964C-6482E4197E10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735079" y="4411323"/>
                          <a:ext cx="546082" cy="26161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fr-FR" sz="1100" b="1" i="1" dirty="0" err="1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perR</a:t>
                          </a:r>
                          <a:endParaRPr lang="fr-FR" sz="1100" b="1" i="1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grpSp>
                      <p:nvGrpSpPr>
                        <p:cNvPr id="432" name="Groupe 431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F886AD0C-93B4-BE49-A4DA-6C703EBA3588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5789763" y="4166074"/>
                          <a:ext cx="454881" cy="276999"/>
                          <a:chOff x="5789763" y="4166074"/>
                          <a:chExt cx="454881" cy="276999"/>
                        </a:xfrm>
                      </p:grpSpPr>
                      <p:sp>
                        <p:nvSpPr>
                          <p:cNvPr id="433" name="ZoneTexte 432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85CE4605-FE6E-4946-90A7-13A4182E02C4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5789763" y="4166074"/>
                            <a:ext cx="231779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-</a:t>
                            </a:r>
                          </a:p>
                        </p:txBody>
                      </p:sp>
                      <p:sp>
                        <p:nvSpPr>
                          <p:cNvPr id="434" name="ZoneTexte 433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C2A2C0DA-0113-9B4B-8E53-7901C57F5D96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5983034" y="4166074"/>
                            <a:ext cx="261610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+</a:t>
                            </a:r>
                          </a:p>
                        </p:txBody>
                      </p:sp>
                      <p:sp>
                        <p:nvSpPr>
                          <p:cNvPr id="435" name="Parenthèse ouvrante 434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3E171D5C-F686-A440-882B-449CBDA94EAB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 rot="16200000">
                            <a:off x="5969056" y="4196434"/>
                            <a:ext cx="72000" cy="383177"/>
                          </a:xfrm>
                          <a:prstGeom prst="leftBracket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fr-FR"/>
                          </a:p>
                        </p:txBody>
                      </p:sp>
                    </p:grpSp>
                  </p:grpSp>
                  <p:grpSp>
                    <p:nvGrpSpPr>
                      <p:cNvPr id="425" name="Groupe 424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BC7F260B-4DE5-2B4A-90A5-341C04BF8995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5368916" y="4159724"/>
                        <a:ext cx="464067" cy="513209"/>
                        <a:chOff x="5368916" y="4159724"/>
                        <a:chExt cx="464067" cy="513209"/>
                      </a:xfrm>
                    </p:grpSpPr>
                    <p:sp>
                      <p:nvSpPr>
                        <p:cNvPr id="426" name="ZoneTexte 425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FA645FF1-27D5-E645-92C4-761933A494BF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383465" y="4411323"/>
                          <a:ext cx="416801" cy="26161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fr-FR" sz="1100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WT</a:t>
                          </a:r>
                        </a:p>
                      </p:txBody>
                    </p:sp>
                    <p:grpSp>
                      <p:nvGrpSpPr>
                        <p:cNvPr id="427" name="Groupe 426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C9894513-3D17-9846-AA17-9A6B82CF6756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5368916" y="4159724"/>
                          <a:ext cx="464067" cy="283349"/>
                          <a:chOff x="5368916" y="4159724"/>
                          <a:chExt cx="464067" cy="283349"/>
                        </a:xfrm>
                      </p:grpSpPr>
                      <p:sp>
                        <p:nvSpPr>
                          <p:cNvPr id="428" name="ZoneTexte 427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15C5D8EA-FAB0-1A49-9D14-7528B175072D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5368916" y="4159724"/>
                            <a:ext cx="231779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-</a:t>
                            </a:r>
                          </a:p>
                        </p:txBody>
                      </p:sp>
                      <p:sp>
                        <p:nvSpPr>
                          <p:cNvPr id="429" name="ZoneTexte 428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7E7FF421-BDE3-4F4C-8341-365D2391AAAB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5571373" y="4166074"/>
                            <a:ext cx="261610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+</a:t>
                            </a:r>
                          </a:p>
                        </p:txBody>
                      </p:sp>
                      <p:sp>
                        <p:nvSpPr>
                          <p:cNvPr id="430" name="Parenthèse ouvrante 429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7F7F1429-8952-8647-80A8-2A43E0452610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 rot="16200000">
                            <a:off x="5558281" y="4197440"/>
                            <a:ext cx="72000" cy="383177"/>
                          </a:xfrm>
                          <a:prstGeom prst="leftBracket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fr-FR"/>
                          </a:p>
                        </p:txBody>
                      </p:sp>
                    </p:grpSp>
                  </p:grpSp>
                </p:grpSp>
                <p:grpSp>
                  <p:nvGrpSpPr>
                    <p:cNvPr id="436" name="Groupe 435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B0E67D24-D583-B644-AC0E-6882CD663F0D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7255687" y="3793247"/>
                      <a:ext cx="912245" cy="815098"/>
                      <a:chOff x="5368916" y="4159724"/>
                      <a:chExt cx="912245" cy="815098"/>
                    </a:xfrm>
                  </p:grpSpPr>
                  <p:sp>
                    <p:nvSpPr>
                      <p:cNvPr id="437" name="Parenthèse ouvrante 436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E20F2761-349D-F641-9FB4-73AF82829049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5775772" y="4258172"/>
                        <a:ext cx="58640" cy="845946"/>
                      </a:xfrm>
                      <a:prstGeom prst="leftBracket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fr-FR"/>
                      </a:p>
                    </p:txBody>
                  </p:sp>
                  <p:sp>
                    <p:nvSpPr>
                      <p:cNvPr id="438" name="ZoneTexte 437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71EA5E02-1332-D543-B54E-F731278D3E24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5569121" y="4697823"/>
                        <a:ext cx="490840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fr-FR" sz="12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BC5</a:t>
                        </a:r>
                      </a:p>
                    </p:txBody>
                  </p:sp>
                  <p:grpSp>
                    <p:nvGrpSpPr>
                      <p:cNvPr id="439" name="Groupe 438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FA1ADA7A-17A2-5D42-8C42-25D49BB36189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5735079" y="4166074"/>
                        <a:ext cx="546082" cy="506859"/>
                        <a:chOff x="5735079" y="4166074"/>
                        <a:chExt cx="546082" cy="506859"/>
                      </a:xfrm>
                    </p:grpSpPr>
                    <p:sp>
                      <p:nvSpPr>
                        <p:cNvPr id="446" name="ZoneTexte 445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EB9E416F-00A9-6D47-B3A2-2ED43E9149C9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735079" y="4411323"/>
                          <a:ext cx="546082" cy="26161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fr-FR" sz="1100" b="1" i="1" dirty="0" err="1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perR</a:t>
                          </a:r>
                          <a:endParaRPr lang="fr-FR" sz="1100" b="1" i="1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grpSp>
                      <p:nvGrpSpPr>
                        <p:cNvPr id="447" name="Groupe 446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6B052824-0E27-114E-BACC-53C39989CC01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5789763" y="4166074"/>
                          <a:ext cx="454881" cy="276999"/>
                          <a:chOff x="5789763" y="4166074"/>
                          <a:chExt cx="454881" cy="276999"/>
                        </a:xfrm>
                      </p:grpSpPr>
                      <p:sp>
                        <p:nvSpPr>
                          <p:cNvPr id="448" name="ZoneTexte 447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10202853-EFEC-9C44-A0D7-B56B02B8DDDF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5789763" y="4166074"/>
                            <a:ext cx="231779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-</a:t>
                            </a:r>
                          </a:p>
                        </p:txBody>
                      </p:sp>
                      <p:sp>
                        <p:nvSpPr>
                          <p:cNvPr id="449" name="ZoneTexte 448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67DE35A7-736B-7B47-9A52-6D6AEF1874F2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5983034" y="4166074"/>
                            <a:ext cx="261610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+</a:t>
                            </a:r>
                          </a:p>
                        </p:txBody>
                      </p:sp>
                      <p:sp>
                        <p:nvSpPr>
                          <p:cNvPr id="450" name="Parenthèse ouvrante 449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3DB5C6A9-0228-EE40-892F-805A30827FB9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 rot="16200000">
                            <a:off x="5969056" y="4196434"/>
                            <a:ext cx="72000" cy="383177"/>
                          </a:xfrm>
                          <a:prstGeom prst="leftBracket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fr-FR"/>
                          </a:p>
                        </p:txBody>
                      </p:sp>
                    </p:grpSp>
                  </p:grpSp>
                  <p:grpSp>
                    <p:nvGrpSpPr>
                      <p:cNvPr id="440" name="Groupe 439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381E815B-7F96-1D47-AC4B-AFEEBE030D56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5368916" y="4159724"/>
                        <a:ext cx="464067" cy="513209"/>
                        <a:chOff x="5368916" y="4159724"/>
                        <a:chExt cx="464067" cy="513209"/>
                      </a:xfrm>
                    </p:grpSpPr>
                    <p:sp>
                      <p:nvSpPr>
                        <p:cNvPr id="441" name="ZoneTexte 440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7DD60F1B-F64F-A645-8F25-90A86E426905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383465" y="4411323"/>
                          <a:ext cx="416801" cy="26161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fr-FR" sz="1100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WT</a:t>
                          </a:r>
                        </a:p>
                      </p:txBody>
                    </p:sp>
                    <p:grpSp>
                      <p:nvGrpSpPr>
                        <p:cNvPr id="442" name="Groupe 441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6829FFD9-017C-844B-BFF6-557CE813618B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5368916" y="4159724"/>
                          <a:ext cx="464067" cy="283349"/>
                          <a:chOff x="5368916" y="4159724"/>
                          <a:chExt cx="464067" cy="283349"/>
                        </a:xfrm>
                      </p:grpSpPr>
                      <p:sp>
                        <p:nvSpPr>
                          <p:cNvPr id="443" name="ZoneTexte 442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4AFFC5A7-7E05-724A-9D93-CE621C595AAE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5368916" y="4159724"/>
                            <a:ext cx="231779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-</a:t>
                            </a:r>
                          </a:p>
                        </p:txBody>
                      </p:sp>
                      <p:sp>
                        <p:nvSpPr>
                          <p:cNvPr id="444" name="ZoneTexte 443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B08FFC46-EF79-EC46-8945-A81616C1AE05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5571373" y="4166074"/>
                            <a:ext cx="261610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+</a:t>
                            </a:r>
                          </a:p>
                        </p:txBody>
                      </p:sp>
                      <p:sp>
                        <p:nvSpPr>
                          <p:cNvPr id="445" name="Parenthèse ouvrante 444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A972BCE4-58E7-E443-B7FE-D893A267E949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 rot="16200000">
                            <a:off x="5558281" y="4197440"/>
                            <a:ext cx="72000" cy="383177"/>
                          </a:xfrm>
                          <a:prstGeom prst="leftBracket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fr-FR"/>
                          </a:p>
                        </p:txBody>
                      </p:sp>
                    </p:grpSp>
                  </p:grpSp>
                </p:grpSp>
                <p:grpSp>
                  <p:nvGrpSpPr>
                    <p:cNvPr id="451" name="Groupe 450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1AA806DD-11D5-884A-9C9D-5DBC1FE5B1CD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219543" y="3794254"/>
                      <a:ext cx="912245" cy="815098"/>
                      <a:chOff x="5368916" y="4159724"/>
                      <a:chExt cx="912245" cy="815098"/>
                    </a:xfrm>
                  </p:grpSpPr>
                  <p:sp>
                    <p:nvSpPr>
                      <p:cNvPr id="452" name="Parenthèse ouvrante 451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2607FB78-EA5E-B141-AFDA-883EA5A1B8D2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5775772" y="4258172"/>
                        <a:ext cx="58640" cy="845946"/>
                      </a:xfrm>
                      <a:prstGeom prst="leftBracket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fr-FR"/>
                      </a:p>
                    </p:txBody>
                  </p:sp>
                  <p:sp>
                    <p:nvSpPr>
                      <p:cNvPr id="453" name="ZoneTexte 452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7949260C-B1C9-CE45-A41C-9254848D7EA5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5569121" y="4697823"/>
                        <a:ext cx="490840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fr-FR" sz="12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BC7</a:t>
                        </a:r>
                      </a:p>
                    </p:txBody>
                  </p:sp>
                  <p:grpSp>
                    <p:nvGrpSpPr>
                      <p:cNvPr id="454" name="Groupe 453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E3441170-0A62-214D-9615-6ACE86FA2784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5735079" y="4166074"/>
                        <a:ext cx="546082" cy="506859"/>
                        <a:chOff x="5735079" y="4166074"/>
                        <a:chExt cx="546082" cy="506859"/>
                      </a:xfrm>
                    </p:grpSpPr>
                    <p:sp>
                      <p:nvSpPr>
                        <p:cNvPr id="461" name="ZoneTexte 460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FA3B861A-F72C-DC4F-AABB-3FE50F41B3DF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735079" y="4411323"/>
                          <a:ext cx="546082" cy="26161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fr-FR" sz="1100" b="1" i="1" dirty="0" err="1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perR</a:t>
                          </a:r>
                          <a:endParaRPr lang="fr-FR" sz="1100" b="1" i="1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grpSp>
                      <p:nvGrpSpPr>
                        <p:cNvPr id="462" name="Groupe 461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5C38A997-ADA2-644A-9FA3-65B29437A4CB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5789763" y="4166074"/>
                          <a:ext cx="454881" cy="276999"/>
                          <a:chOff x="5789763" y="4166074"/>
                          <a:chExt cx="454881" cy="276999"/>
                        </a:xfrm>
                      </p:grpSpPr>
                      <p:sp>
                        <p:nvSpPr>
                          <p:cNvPr id="463" name="ZoneTexte 462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D60AEF4A-BE7B-8145-A0D8-A909D6968C1C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5789763" y="4166074"/>
                            <a:ext cx="231779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-</a:t>
                            </a:r>
                          </a:p>
                        </p:txBody>
                      </p:sp>
                      <p:sp>
                        <p:nvSpPr>
                          <p:cNvPr id="464" name="ZoneTexte 463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05977F3D-E3CB-5D4F-A1CF-A20783AB36DD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5983034" y="4166074"/>
                            <a:ext cx="261610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+</a:t>
                            </a:r>
                          </a:p>
                        </p:txBody>
                      </p:sp>
                      <p:sp>
                        <p:nvSpPr>
                          <p:cNvPr id="465" name="Parenthèse ouvrante 464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ABB2FBA9-05B6-1E46-A1D2-47C448C33506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 rot="16200000">
                            <a:off x="5969056" y="4196434"/>
                            <a:ext cx="72000" cy="383177"/>
                          </a:xfrm>
                          <a:prstGeom prst="leftBracket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fr-FR"/>
                          </a:p>
                        </p:txBody>
                      </p:sp>
                    </p:grpSp>
                  </p:grpSp>
                  <p:grpSp>
                    <p:nvGrpSpPr>
                      <p:cNvPr id="455" name="Groupe 454">
                        <a:extLst>
                          <a:ext uri="{FF2B5EF4-FFF2-40B4-BE49-F238E27FC236}">
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BE1530EB-0EF3-4844-85FC-A8F82342CE07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5368916" y="4159724"/>
                        <a:ext cx="464067" cy="513209"/>
                        <a:chOff x="5368916" y="4159724"/>
                        <a:chExt cx="464067" cy="513209"/>
                      </a:xfrm>
                    </p:grpSpPr>
                    <p:sp>
                      <p:nvSpPr>
                        <p:cNvPr id="456" name="ZoneTexte 455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1FE767BB-E07A-5C47-9BF9-3660160E9BED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383465" y="4411323"/>
                          <a:ext cx="416801" cy="26161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fr-FR" sz="1100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WT</a:t>
                          </a:r>
                        </a:p>
                      </p:txBody>
                    </p:sp>
                    <p:grpSp>
                      <p:nvGrpSpPr>
                        <p:cNvPr id="457" name="Groupe 456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7045BADD-D641-4C41-9839-72B2162325AA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5368916" y="4159724"/>
                          <a:ext cx="464067" cy="283349"/>
                          <a:chOff x="5368916" y="4159724"/>
                          <a:chExt cx="464067" cy="283349"/>
                        </a:xfrm>
                      </p:grpSpPr>
                      <p:sp>
                        <p:nvSpPr>
                          <p:cNvPr id="458" name="ZoneTexte 457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A38488B1-8A68-D544-86E6-D9BF820BBD4F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5368916" y="4159724"/>
                            <a:ext cx="231779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-</a:t>
                            </a:r>
                          </a:p>
                        </p:txBody>
                      </p:sp>
                      <p:sp>
                        <p:nvSpPr>
                          <p:cNvPr id="459" name="ZoneTexte 458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3731E31D-0D38-3B4B-B793-A4FF91197C3C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5571373" y="4166074"/>
                            <a:ext cx="261610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+</a:t>
                            </a:r>
                          </a:p>
                        </p:txBody>
                      </p:sp>
                      <p:sp>
                        <p:nvSpPr>
                          <p:cNvPr id="460" name="Parenthèse ouvrante 459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D96C5377-B50F-694C-90BE-EBEDFAA407C3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 rot="16200000">
                            <a:off x="5558281" y="4197440"/>
                            <a:ext cx="72000" cy="383177"/>
                          </a:xfrm>
                          <a:prstGeom prst="leftBracket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fr-FR"/>
                          </a:p>
                        </p:txBody>
                      </p:sp>
                    </p:grpSp>
                  </p:grpSp>
                </p:grpSp>
              </p:grpSp>
              <p:sp>
                <p:nvSpPr>
                  <p:cNvPr id="258" name="ZoneTexte 257">
                    <a:extLst>
                      <a:ext uri="{FF2B5EF4-FFF2-40B4-BE49-F238E27FC236}">
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42BDD0EF-23E8-F64B-8710-9E701F122F99}"/>
                      </a:ext>
                    </a:extLst>
                  </p:cNvPr>
                  <p:cNvSpPr txBox="1"/>
                  <p:nvPr/>
                </p:nvSpPr>
                <p:spPr>
                  <a:xfrm>
                    <a:off x="9021013" y="3801967"/>
                    <a:ext cx="718466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10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ntibody</a:t>
                    </a:r>
                    <a:endParaRPr lang="fr-FR" sz="10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sp>
            <p:nvSpPr>
              <p:cNvPr id="263" name="ZoneTexte 262"/>
              <p:cNvSpPr txBox="1"/>
              <p:nvPr/>
            </p:nvSpPr>
            <p:spPr>
              <a:xfrm>
                <a:off x="355449" y="2187119"/>
                <a:ext cx="166700" cy="276999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noAutofit/>
              </a:bodyPr>
              <a:lstStyle/>
              <a:p>
                <a:r>
                  <a:rPr lang="fr-FR" b="1" dirty="0" smtClean="0">
                    <a:latin typeface="Arial"/>
                    <a:cs typeface="Arial"/>
                  </a:rPr>
                  <a:t>B</a:t>
                </a:r>
                <a:endParaRPr lang="fr-FR" b="1" dirty="0">
                  <a:latin typeface="Arial"/>
                  <a:cs typeface="Arial"/>
                </a:endParaRPr>
              </a:p>
            </p:txBody>
          </p:sp>
        </p:grpSp>
        <p:grpSp>
          <p:nvGrpSpPr>
            <p:cNvPr id="268" name="Grouper 267"/>
            <p:cNvGrpSpPr/>
            <p:nvPr/>
          </p:nvGrpSpPr>
          <p:grpSpPr>
            <a:xfrm>
              <a:off x="355449" y="4586787"/>
              <a:ext cx="7849268" cy="2244564"/>
              <a:chOff x="355449" y="4586787"/>
              <a:chExt cx="7849268" cy="2244564"/>
            </a:xfrm>
          </p:grpSpPr>
          <p:grpSp>
            <p:nvGrpSpPr>
              <p:cNvPr id="43" name="Groupe 42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B5F520EB-DF08-5E42-B815-A7088522437B}"/>
                  </a:ext>
                </a:extLst>
              </p:cNvPr>
              <p:cNvGrpSpPr/>
              <p:nvPr/>
            </p:nvGrpSpPr>
            <p:grpSpPr>
              <a:xfrm>
                <a:off x="426851" y="4586787"/>
                <a:ext cx="7777866" cy="2244564"/>
                <a:chOff x="426851" y="4586787"/>
                <a:chExt cx="7777866" cy="2244564"/>
              </a:xfrm>
            </p:grpSpPr>
            <p:grpSp>
              <p:nvGrpSpPr>
                <p:cNvPr id="12" name="Groupe 11">
                  <a:extLst>
                    <a:ext uri="{FF2B5EF4-FFF2-40B4-BE49-F238E27FC236}">
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AD45B05F-C80C-6A4F-9174-FD15AA6AB287}"/>
                    </a:ext>
                  </a:extLst>
                </p:cNvPr>
                <p:cNvGrpSpPr/>
                <p:nvPr/>
              </p:nvGrpSpPr>
              <p:grpSpPr>
                <a:xfrm>
                  <a:off x="426851" y="5090954"/>
                  <a:ext cx="4170971" cy="1087136"/>
                  <a:chOff x="426851" y="5090954"/>
                  <a:chExt cx="4170971" cy="1087136"/>
                </a:xfrm>
              </p:grpSpPr>
              <p:grpSp>
                <p:nvGrpSpPr>
                  <p:cNvPr id="106" name="Grouper 105"/>
                  <p:cNvGrpSpPr/>
                  <p:nvPr/>
                </p:nvGrpSpPr>
                <p:grpSpPr>
                  <a:xfrm>
                    <a:off x="808326" y="5090954"/>
                    <a:ext cx="1003037" cy="398386"/>
                    <a:chOff x="1046451" y="2935605"/>
                    <a:chExt cx="1300076" cy="398386"/>
                  </a:xfrm>
                </p:grpSpPr>
                <p:sp>
                  <p:nvSpPr>
                    <p:cNvPr id="107" name="TextBox 23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13C4D056-344F-404B-B797-86232494965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311562" y="2935605"/>
                      <a:ext cx="769854" cy="15388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1000" b="1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000" b="1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hpC</a:t>
                      </a:r>
                      <a:endParaRPr lang="en-US" sz="1000" b="1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08" name="TextBox 20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D90D51D4-C5BA-5048-8AD6-22CB9DEBB6A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046451" y="3180103"/>
                      <a:ext cx="1300076" cy="15388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MLP_05955</a:t>
                      </a:r>
                    </a:p>
                  </p:txBody>
                </p:sp>
              </p:grpSp>
              <p:grpSp>
                <p:nvGrpSpPr>
                  <p:cNvPr id="109" name="Grouper 108"/>
                  <p:cNvGrpSpPr/>
                  <p:nvPr/>
                </p:nvGrpSpPr>
                <p:grpSpPr>
                  <a:xfrm>
                    <a:off x="2921442" y="5090954"/>
                    <a:ext cx="1100403" cy="398386"/>
                    <a:chOff x="4551582" y="2935605"/>
                    <a:chExt cx="1100403" cy="398386"/>
                  </a:xfrm>
                </p:grpSpPr>
                <p:sp>
                  <p:nvSpPr>
                    <p:cNvPr id="110" name="TextBox 24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CFF72D2A-C10B-E944-985C-4F5A0C03A5C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847081" y="2935605"/>
                      <a:ext cx="509405" cy="15388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1000" b="1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fB</a:t>
                      </a:r>
                      <a:endParaRPr lang="en-US" sz="1000" b="1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11" name="TextBox 20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100BF287-828D-1444-B3C2-F752BB52B8E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551582" y="3180103"/>
                      <a:ext cx="1100403" cy="15388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MLP_05960</a:t>
                      </a:r>
                    </a:p>
                  </p:txBody>
                </p:sp>
              </p:grpSp>
              <p:sp>
                <p:nvSpPr>
                  <p:cNvPr id="112" name="TextBox 20">
                    <a:extLst>
                      <a:ext uri="{FF2B5EF4-FFF2-40B4-BE49-F238E27FC236}">
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04127524-1458-9C42-A446-9D8175005AEF}"/>
                      </a:ext>
                    </a:extLst>
                  </p:cNvPr>
                  <p:cNvSpPr txBox="1"/>
                  <p:nvPr/>
                </p:nvSpPr>
                <p:spPr>
                  <a:xfrm>
                    <a:off x="1704742" y="5148433"/>
                    <a:ext cx="838797" cy="307777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EPIMA</a:t>
                    </a:r>
                  </a:p>
                  <a:p>
                    <a:pPr algn="ctr"/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_CI1314</a:t>
                    </a:r>
                  </a:p>
                </p:txBody>
              </p:sp>
              <p:cxnSp>
                <p:nvCxnSpPr>
                  <p:cNvPr id="114" name="Straight Connector 10">
                    <a:extLst>
                      <a:ext uri="{FF2B5EF4-FFF2-40B4-BE49-F238E27FC236}">
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9238ADF0-5D2A-EE4E-A464-DE64EB668F82}"/>
                      </a:ext>
                    </a:extLst>
                  </p:cNvPr>
                  <p:cNvCxnSpPr>
                    <a:cxnSpLocks noChangeAspect="1"/>
                  </p:cNvCxnSpPr>
                  <p:nvPr/>
                </p:nvCxnSpPr>
                <p:spPr>
                  <a:xfrm flipV="1">
                    <a:off x="495921" y="5602509"/>
                    <a:ext cx="2234998" cy="15442"/>
                  </a:xfrm>
                  <a:prstGeom prst="line">
                    <a:avLst/>
                  </a:prstGeom>
                  <a:ln>
                    <a:headEnd type="none" w="med" len="med"/>
                    <a:tailEnd type="none" w="med" len="med"/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15" name="Down Arrow 14">
                    <a:extLst>
                      <a:ext uri="{FF2B5EF4-FFF2-40B4-BE49-F238E27FC236}">
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01B76F58-635A-B449-813B-AC539E25A753}"/>
                      </a:ext>
                    </a:extLst>
                  </p:cNvPr>
                  <p:cNvSpPr>
                    <a:spLocks/>
                  </p:cNvSpPr>
                  <p:nvPr/>
                </p:nvSpPr>
                <p:spPr>
                  <a:xfrm rot="16200000" flipH="1">
                    <a:off x="1195096" y="5214894"/>
                    <a:ext cx="238085" cy="786971"/>
                  </a:xfrm>
                  <a:prstGeom prst="downArrow">
                    <a:avLst/>
                  </a:prstGeom>
                  <a:solidFill>
                    <a:srgbClr val="00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vert="vert270" rtlCol="0" anchor="ctr"/>
                  <a:lstStyle/>
                  <a:p>
                    <a:pPr algn="ctr"/>
                    <a:endParaRPr lang="en-US" sz="1000" b="1" dirty="0">
                      <a:solidFill>
                        <a:srgbClr val="FFFF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16" name="Down Arrow 14">
                    <a:extLst>
                      <a:ext uri="{FF2B5EF4-FFF2-40B4-BE49-F238E27FC236}">
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B8E0DCBB-A667-A642-93EB-5B742502C91E}"/>
                      </a:ext>
                    </a:extLst>
                  </p:cNvPr>
                  <p:cNvSpPr>
                    <a:spLocks/>
                  </p:cNvSpPr>
                  <p:nvPr/>
                </p:nvSpPr>
                <p:spPr>
                  <a:xfrm rot="16200000" flipH="1">
                    <a:off x="3408498" y="4538099"/>
                    <a:ext cx="238085" cy="2140562"/>
                  </a:xfrm>
                  <a:prstGeom prst="downArrow">
                    <a:avLst/>
                  </a:prstGeom>
                  <a:solidFill>
                    <a:srgbClr val="00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vert="vert270" rtlCol="0" anchor="ctr"/>
                  <a:lstStyle/>
                  <a:p>
                    <a:pPr algn="ctr"/>
                    <a:endParaRPr lang="en-US" sz="1000" b="1" dirty="0">
                      <a:solidFill>
                        <a:srgbClr val="FFFF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17" name="Down Arrow 14">
                    <a:extLst>
                      <a:ext uri="{FF2B5EF4-FFF2-40B4-BE49-F238E27FC236}">
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A3E074AD-5BF2-E244-99D9-F8985A236A06}"/>
                      </a:ext>
                    </a:extLst>
                  </p:cNvPr>
                  <p:cNvSpPr>
                    <a:spLocks/>
                  </p:cNvSpPr>
                  <p:nvPr/>
                </p:nvSpPr>
                <p:spPr>
                  <a:xfrm rot="5400000">
                    <a:off x="1984348" y="5443544"/>
                    <a:ext cx="224776" cy="329671"/>
                  </a:xfrm>
                  <a:prstGeom prst="downArrow">
                    <a:avLst/>
                  </a:prstGeom>
                  <a:solidFill>
                    <a:srgbClr val="00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vert="vert270" rtlCol="0" anchor="ctr"/>
                  <a:lstStyle/>
                  <a:p>
                    <a:pPr algn="ctr"/>
                    <a:endParaRPr lang="en-US" sz="1000" b="1" dirty="0">
                      <a:solidFill>
                        <a:srgbClr val="FFFF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grpSp>
                <p:nvGrpSpPr>
                  <p:cNvPr id="118" name="Groupe 45">
                    <a:extLst>
                      <a:ext uri="{FF2B5EF4-FFF2-40B4-BE49-F238E27FC236}">
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D859C635-98BA-874F-A8F1-718A719A3538}"/>
                      </a:ext>
                    </a:extLst>
                  </p:cNvPr>
                  <p:cNvGrpSpPr/>
                  <p:nvPr/>
                </p:nvGrpSpPr>
                <p:grpSpPr>
                  <a:xfrm>
                    <a:off x="550664" y="5701332"/>
                    <a:ext cx="450127" cy="177828"/>
                    <a:chOff x="4829702" y="2291532"/>
                    <a:chExt cx="1029553" cy="215714"/>
                  </a:xfrm>
                </p:grpSpPr>
                <p:sp>
                  <p:nvSpPr>
                    <p:cNvPr id="122" name="TextBox 25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AA181573-06B1-0744-B895-87C2D9FF8EA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829702" y="2320572"/>
                      <a:ext cx="1029553" cy="18667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1000" b="1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hpC3</a:t>
                      </a:r>
                    </a:p>
                  </p:txBody>
                </p:sp>
                <p:cxnSp>
                  <p:nvCxnSpPr>
                    <p:cNvPr id="123" name="Connecteur droit avec flèche 122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7584F126-48BB-0B44-A710-B533044E5D48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5186886" y="2291532"/>
                      <a:ext cx="276447" cy="0"/>
                    </a:xfrm>
                    <a:prstGeom prst="straightConnector1">
                      <a:avLst/>
                    </a:prstGeom>
                    <a:ln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119" name="Groupe 52">
                    <a:extLst>
                      <a:ext uri="{FF2B5EF4-FFF2-40B4-BE49-F238E27FC236}">
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60C6023A-3F81-5145-AC94-208967CC3B9D}"/>
                      </a:ext>
                    </a:extLst>
                  </p:cNvPr>
                  <p:cNvGrpSpPr/>
                  <p:nvPr/>
                </p:nvGrpSpPr>
                <p:grpSpPr>
                  <a:xfrm>
                    <a:off x="426851" y="5986108"/>
                    <a:ext cx="471095" cy="191982"/>
                    <a:chOff x="4788298" y="2291532"/>
                    <a:chExt cx="1077512" cy="232884"/>
                  </a:xfrm>
                </p:grpSpPr>
                <p:sp>
                  <p:nvSpPr>
                    <p:cNvPr id="120" name="TextBox 25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9ADCB242-DC6A-A046-858E-0127154E78F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788298" y="2337742"/>
                      <a:ext cx="1077512" cy="18667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hpC5</a:t>
                      </a:r>
                    </a:p>
                  </p:txBody>
                </p:sp>
                <p:cxnSp>
                  <p:nvCxnSpPr>
                    <p:cNvPr id="121" name="Connecteur droit avec flèche 120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F2E9CB60-1443-0A4F-B32B-19D0CE42A089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5186886" y="2291532"/>
                      <a:ext cx="276447" cy="0"/>
                    </a:xfrm>
                    <a:prstGeom prst="straightConnector1">
                      <a:avLst/>
                    </a:prstGeom>
                    <a:ln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254" name="TextBox 25">
                    <a:extLst>
                      <a:ext uri="{FF2B5EF4-FFF2-40B4-BE49-F238E27FC236}">
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9AF4A46E-AEB2-0545-950D-069921165EF2}"/>
                      </a:ext>
                    </a:extLst>
                  </p:cNvPr>
                  <p:cNvSpPr txBox="1"/>
                  <p:nvPr/>
                </p:nvSpPr>
                <p:spPr>
                  <a:xfrm>
                    <a:off x="2233089" y="5478541"/>
                    <a:ext cx="224170" cy="123111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b="1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9</a:t>
                    </a:r>
                  </a:p>
                </p:txBody>
              </p:sp>
              <p:sp>
                <p:nvSpPr>
                  <p:cNvPr id="256" name="TextBox 25">
                    <a:extLst>
                      <a:ext uri="{FF2B5EF4-FFF2-40B4-BE49-F238E27FC236}">
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44ACF507-B6A3-4D47-9D44-CB141B4B4885}"/>
                      </a:ext>
                    </a:extLst>
                  </p:cNvPr>
                  <p:cNvSpPr txBox="1"/>
                  <p:nvPr/>
                </p:nvSpPr>
                <p:spPr>
                  <a:xfrm>
                    <a:off x="1715545" y="5478541"/>
                    <a:ext cx="224170" cy="123111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b="1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41</a:t>
                    </a:r>
                  </a:p>
                </p:txBody>
              </p:sp>
            </p:grpSp>
            <p:grpSp>
              <p:nvGrpSpPr>
                <p:cNvPr id="42" name="Groupe 41">
                  <a:extLst>
                    <a:ext uri="{FF2B5EF4-FFF2-40B4-BE49-F238E27FC236}">
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188ED78C-759B-C248-8D73-17C388B39F53}"/>
                    </a:ext>
                  </a:extLst>
                </p:cNvPr>
                <p:cNvGrpSpPr/>
                <p:nvPr/>
              </p:nvGrpSpPr>
              <p:grpSpPr>
                <a:xfrm>
                  <a:off x="4818961" y="4586787"/>
                  <a:ext cx="3385756" cy="2244564"/>
                  <a:chOff x="4818961" y="4586787"/>
                  <a:chExt cx="3385756" cy="2244564"/>
                </a:xfrm>
              </p:grpSpPr>
              <p:grpSp>
                <p:nvGrpSpPr>
                  <p:cNvPr id="30" name="Groupe 29">
                    <a:extLst>
                      <a:ext uri="{FF2B5EF4-FFF2-40B4-BE49-F238E27FC236}">
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01DD4939-54D7-8A4C-8118-6494CF579AE9}"/>
                      </a:ext>
                    </a:extLst>
                  </p:cNvPr>
                  <p:cNvGrpSpPr/>
                  <p:nvPr/>
                </p:nvGrpSpPr>
                <p:grpSpPr>
                  <a:xfrm>
                    <a:off x="4818961" y="4586787"/>
                    <a:ext cx="2817441" cy="2244564"/>
                    <a:chOff x="4818961" y="4586787"/>
                    <a:chExt cx="2817441" cy="2244564"/>
                  </a:xfrm>
                </p:grpSpPr>
                <p:grpSp>
                  <p:nvGrpSpPr>
                    <p:cNvPr id="170" name="Grouper 169"/>
                    <p:cNvGrpSpPr/>
                    <p:nvPr/>
                  </p:nvGrpSpPr>
                  <p:grpSpPr>
                    <a:xfrm>
                      <a:off x="5421243" y="6024714"/>
                      <a:ext cx="947956" cy="806637"/>
                      <a:chOff x="5421243" y="4022387"/>
                      <a:chExt cx="947956" cy="806637"/>
                    </a:xfrm>
                  </p:grpSpPr>
                  <p:grpSp>
                    <p:nvGrpSpPr>
                      <p:cNvPr id="166" name="Grouper 165"/>
                      <p:cNvGrpSpPr/>
                      <p:nvPr/>
                    </p:nvGrpSpPr>
                    <p:grpSpPr>
                      <a:xfrm>
                        <a:off x="5432809" y="4514494"/>
                        <a:ext cx="882000" cy="314530"/>
                        <a:chOff x="5432809" y="4514494"/>
                        <a:chExt cx="882000" cy="314530"/>
                      </a:xfrm>
                    </p:grpSpPr>
                    <p:sp>
                      <p:nvSpPr>
                        <p:cNvPr id="127" name="Parenthèse ouvrante 126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93A3E82E-4844-EC4B-9BA8-645CCA6865E0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6200000">
                          <a:off x="5840002" y="4107301"/>
                          <a:ext cx="67614" cy="882000"/>
                        </a:xfrm>
                        <a:prstGeom prst="leftBracket">
                          <a:avLst/>
                        </a:prstGeom>
                        <a:ln w="12700"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fr-FR"/>
                        </a:p>
                      </p:txBody>
                    </p:sp>
                    <p:sp>
                      <p:nvSpPr>
                        <p:cNvPr id="128" name="ZoneTexte 127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BB379FED-2250-5A49-8491-E0888C57F494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535234" y="4552025"/>
                          <a:ext cx="693344" cy="27699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fr-FR" sz="1200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AhpC3</a:t>
                          </a:r>
                        </a:p>
                      </p:txBody>
                    </p:sp>
                  </p:grpSp>
                  <p:grpSp>
                    <p:nvGrpSpPr>
                      <p:cNvPr id="169" name="Grouper 168"/>
                      <p:cNvGrpSpPr/>
                      <p:nvPr/>
                    </p:nvGrpSpPr>
                    <p:grpSpPr>
                      <a:xfrm>
                        <a:off x="5421243" y="4022393"/>
                        <a:ext cx="482351" cy="544959"/>
                        <a:chOff x="5421243" y="4022393"/>
                        <a:chExt cx="482351" cy="544959"/>
                      </a:xfrm>
                    </p:grpSpPr>
                    <p:grpSp>
                      <p:nvGrpSpPr>
                        <p:cNvPr id="137" name="Grouper 113"/>
                        <p:cNvGrpSpPr/>
                        <p:nvPr/>
                      </p:nvGrpSpPr>
                      <p:grpSpPr>
                        <a:xfrm>
                          <a:off x="5421243" y="4022393"/>
                          <a:ext cx="482351" cy="283349"/>
                          <a:chOff x="2048940" y="8821220"/>
                          <a:chExt cx="482351" cy="283349"/>
                        </a:xfrm>
                      </p:grpSpPr>
                      <p:sp>
                        <p:nvSpPr>
                          <p:cNvPr id="139" name="ZoneTexte 138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847B1F25-D2D1-8C40-BB45-B4E35B190343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2048940" y="8821220"/>
                            <a:ext cx="231779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-</a:t>
                            </a:r>
                          </a:p>
                        </p:txBody>
                      </p:sp>
                      <p:sp>
                        <p:nvSpPr>
                          <p:cNvPr id="140" name="ZoneTexte 139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9310CDDA-AF85-4D4F-A44A-D3F7999A947C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2269681" y="8827570"/>
                            <a:ext cx="261610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+</a:t>
                            </a:r>
                          </a:p>
                        </p:txBody>
                      </p:sp>
                      <p:sp>
                        <p:nvSpPr>
                          <p:cNvPr id="141" name="Parenthèse ouvrante 140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B28519C1-2B29-2640-9859-73301AD2007E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 rot="16200000">
                            <a:off x="2232516" y="8851519"/>
                            <a:ext cx="72000" cy="396000"/>
                          </a:xfrm>
                          <a:prstGeom prst="leftBracket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fr-FR"/>
                          </a:p>
                        </p:txBody>
                      </p:sp>
                    </p:grpSp>
                    <p:sp>
                      <p:nvSpPr>
                        <p:cNvPr id="138" name="ZoneTexte 137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FDD64D3B-E5FF-9547-9DFC-F91E6FA42C04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434616" y="4305742"/>
                          <a:ext cx="416801" cy="26161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pPr algn="ctr"/>
                          <a:r>
                            <a:rPr lang="fr-FR" sz="1100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WT</a:t>
                          </a:r>
                        </a:p>
                      </p:txBody>
                    </p:sp>
                  </p:grpSp>
                  <p:grpSp>
                    <p:nvGrpSpPr>
                      <p:cNvPr id="168" name="Grouper 167"/>
                      <p:cNvGrpSpPr/>
                      <p:nvPr/>
                    </p:nvGrpSpPr>
                    <p:grpSpPr>
                      <a:xfrm>
                        <a:off x="5823117" y="4022387"/>
                        <a:ext cx="546082" cy="544965"/>
                        <a:chOff x="5823117" y="4022387"/>
                        <a:chExt cx="546082" cy="544965"/>
                      </a:xfrm>
                    </p:grpSpPr>
                    <p:sp>
                      <p:nvSpPr>
                        <p:cNvPr id="132" name="ZoneTexte 131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3E5D07DE-750F-1C49-A023-381F4B9464A0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823117" y="4305742"/>
                          <a:ext cx="546082" cy="26161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pPr algn="ctr"/>
                          <a:r>
                            <a:rPr lang="fr-FR" sz="1100" b="1" i="1" dirty="0" err="1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perR</a:t>
                          </a:r>
                          <a:endParaRPr lang="fr-FR" sz="1100" b="1" i="1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grpSp>
                      <p:nvGrpSpPr>
                        <p:cNvPr id="167" name="Grouper 166"/>
                        <p:cNvGrpSpPr/>
                        <p:nvPr/>
                      </p:nvGrpSpPr>
                      <p:grpSpPr>
                        <a:xfrm>
                          <a:off x="5880092" y="4022387"/>
                          <a:ext cx="487403" cy="283349"/>
                          <a:chOff x="5880092" y="4022387"/>
                          <a:chExt cx="487403" cy="283349"/>
                        </a:xfrm>
                      </p:grpSpPr>
                      <p:sp>
                        <p:nvSpPr>
                          <p:cNvPr id="163" name="ZoneTexte 162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847B1F25-D2D1-8C40-BB45-B4E35B190343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5880092" y="4022387"/>
                            <a:ext cx="231779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-</a:t>
                            </a:r>
                          </a:p>
                        </p:txBody>
                      </p:sp>
                      <p:sp>
                        <p:nvSpPr>
                          <p:cNvPr id="164" name="ZoneTexte 163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9310CDDA-AF85-4D4F-A44A-D3F7999A947C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6105885" y="4028737"/>
                            <a:ext cx="261610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+</a:t>
                            </a:r>
                          </a:p>
                        </p:txBody>
                      </p:sp>
                      <p:sp>
                        <p:nvSpPr>
                          <p:cNvPr id="165" name="Parenthèse ouvrante 164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B28519C1-2B29-2640-9859-73301AD2007E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 rot="16200000">
                            <a:off x="6073772" y="4052686"/>
                            <a:ext cx="72000" cy="396000"/>
                          </a:xfrm>
                          <a:prstGeom prst="leftBracket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fr-FR"/>
                          </a:p>
                        </p:txBody>
                      </p:sp>
                    </p:grpSp>
                  </p:grpSp>
                </p:grpSp>
                <p:grpSp>
                  <p:nvGrpSpPr>
                    <p:cNvPr id="171" name="Grouper 170"/>
                    <p:cNvGrpSpPr/>
                    <p:nvPr/>
                  </p:nvGrpSpPr>
                  <p:grpSpPr>
                    <a:xfrm>
                      <a:off x="6553896" y="6024708"/>
                      <a:ext cx="993424" cy="806637"/>
                      <a:chOff x="5461659" y="4022387"/>
                      <a:chExt cx="993424" cy="806637"/>
                    </a:xfrm>
                  </p:grpSpPr>
                  <p:grpSp>
                    <p:nvGrpSpPr>
                      <p:cNvPr id="172" name="Grouper 171"/>
                      <p:cNvGrpSpPr/>
                      <p:nvPr/>
                    </p:nvGrpSpPr>
                    <p:grpSpPr>
                      <a:xfrm>
                        <a:off x="5513641" y="4514494"/>
                        <a:ext cx="882000" cy="314530"/>
                        <a:chOff x="5513641" y="4514494"/>
                        <a:chExt cx="882000" cy="314530"/>
                      </a:xfrm>
                    </p:grpSpPr>
                    <p:sp>
                      <p:nvSpPr>
                        <p:cNvPr id="185" name="Parenthèse ouvrante 184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93A3E82E-4844-EC4B-9BA8-645CCA6865E0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6200000">
                          <a:off x="5920834" y="4107301"/>
                          <a:ext cx="67614" cy="882000"/>
                        </a:xfrm>
                        <a:prstGeom prst="leftBracket">
                          <a:avLst/>
                        </a:prstGeom>
                        <a:ln w="12700"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fr-FR"/>
                        </a:p>
                      </p:txBody>
                    </p:sp>
                    <p:sp>
                      <p:nvSpPr>
                        <p:cNvPr id="186" name="ZoneTexte 185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BB379FED-2250-5A49-8491-E0888C57F494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535234" y="4552025"/>
                          <a:ext cx="693344" cy="27699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fr-FR" sz="1200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AhpC5</a:t>
                          </a:r>
                        </a:p>
                      </p:txBody>
                    </p:sp>
                  </p:grpSp>
                  <p:grpSp>
                    <p:nvGrpSpPr>
                      <p:cNvPr id="173" name="Grouper 172"/>
                      <p:cNvGrpSpPr/>
                      <p:nvPr/>
                    </p:nvGrpSpPr>
                    <p:grpSpPr>
                      <a:xfrm>
                        <a:off x="5461659" y="4022393"/>
                        <a:ext cx="492455" cy="544959"/>
                        <a:chOff x="5461659" y="4022393"/>
                        <a:chExt cx="492455" cy="544959"/>
                      </a:xfrm>
                    </p:grpSpPr>
                    <p:grpSp>
                      <p:nvGrpSpPr>
                        <p:cNvPr id="180" name="Grouper 113"/>
                        <p:cNvGrpSpPr/>
                        <p:nvPr/>
                      </p:nvGrpSpPr>
                      <p:grpSpPr>
                        <a:xfrm>
                          <a:off x="5461659" y="4022393"/>
                          <a:ext cx="492455" cy="283349"/>
                          <a:chOff x="2089356" y="8821220"/>
                          <a:chExt cx="492455" cy="283349"/>
                        </a:xfrm>
                      </p:grpSpPr>
                      <p:sp>
                        <p:nvSpPr>
                          <p:cNvPr id="182" name="ZoneTexte 181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847B1F25-D2D1-8C40-BB45-B4E35B190343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2089356" y="8821220"/>
                            <a:ext cx="231779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-</a:t>
                            </a:r>
                          </a:p>
                        </p:txBody>
                      </p:sp>
                      <p:sp>
                        <p:nvSpPr>
                          <p:cNvPr id="183" name="ZoneTexte 182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9310CDDA-AF85-4D4F-A44A-D3F7999A947C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2320201" y="8827570"/>
                            <a:ext cx="261610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+</a:t>
                            </a:r>
                          </a:p>
                        </p:txBody>
                      </p:sp>
                      <p:sp>
                        <p:nvSpPr>
                          <p:cNvPr id="184" name="Parenthèse ouvrante 183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B28519C1-2B29-2640-9859-73301AD2007E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 rot="16200000">
                            <a:off x="2293140" y="8851519"/>
                            <a:ext cx="72000" cy="396000"/>
                          </a:xfrm>
                          <a:prstGeom prst="leftBracket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fr-FR" dirty="0"/>
                          </a:p>
                        </p:txBody>
                      </p:sp>
                    </p:grpSp>
                    <p:sp>
                      <p:nvSpPr>
                        <p:cNvPr id="181" name="ZoneTexte 180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FDD64D3B-E5FF-9547-9DFC-F91E6FA42C04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500292" y="4305742"/>
                          <a:ext cx="416801" cy="26161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pPr algn="ctr"/>
                          <a:r>
                            <a:rPr lang="fr-FR" sz="1100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WT</a:t>
                          </a:r>
                        </a:p>
                      </p:txBody>
                    </p:sp>
                  </p:grpSp>
                  <p:grpSp>
                    <p:nvGrpSpPr>
                      <p:cNvPr id="174" name="Grouper 173"/>
                      <p:cNvGrpSpPr/>
                      <p:nvPr/>
                    </p:nvGrpSpPr>
                    <p:grpSpPr>
                      <a:xfrm>
                        <a:off x="5909001" y="4022387"/>
                        <a:ext cx="546082" cy="544965"/>
                        <a:chOff x="5909001" y="4022387"/>
                        <a:chExt cx="546082" cy="544965"/>
                      </a:xfrm>
                    </p:grpSpPr>
                    <p:sp>
                      <p:nvSpPr>
                        <p:cNvPr id="175" name="ZoneTexte 174">
                          <a:extLst>
                            <a:ext uri="{FF2B5EF4-FFF2-40B4-BE49-F238E27FC236}">
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3E5D07DE-750F-1C49-A023-381F4B9464A0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909001" y="4305742"/>
                          <a:ext cx="546082" cy="26161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pPr algn="ctr"/>
                          <a:r>
                            <a:rPr lang="fr-FR" sz="1100" b="1" i="1" dirty="0" err="1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perR</a:t>
                          </a:r>
                          <a:endParaRPr lang="fr-FR" sz="1100" b="1" i="1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grpSp>
                      <p:nvGrpSpPr>
                        <p:cNvPr id="176" name="Grouper 175"/>
                        <p:cNvGrpSpPr/>
                        <p:nvPr/>
                      </p:nvGrpSpPr>
                      <p:grpSpPr>
                        <a:xfrm>
                          <a:off x="5925560" y="4022387"/>
                          <a:ext cx="497507" cy="283349"/>
                          <a:chOff x="5925560" y="4022387"/>
                          <a:chExt cx="497507" cy="283349"/>
                        </a:xfrm>
                      </p:grpSpPr>
                      <p:sp>
                        <p:nvSpPr>
                          <p:cNvPr id="177" name="ZoneTexte 176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847B1F25-D2D1-8C40-BB45-B4E35B190343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5925560" y="4022387"/>
                            <a:ext cx="231779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-</a:t>
                            </a:r>
                          </a:p>
                        </p:txBody>
                      </p:sp>
                      <p:sp>
                        <p:nvSpPr>
                          <p:cNvPr id="178" name="ZoneTexte 177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9310CDDA-AF85-4D4F-A44A-D3F7999A947C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6161457" y="4028737"/>
                            <a:ext cx="261610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fr-FR" sz="1200" b="1" dirty="0"/>
                              <a:t>+</a:t>
                            </a:r>
                          </a:p>
                        </p:txBody>
                      </p:sp>
                      <p:sp>
                        <p:nvSpPr>
                          <p:cNvPr id="179" name="Parenthèse ouvrante 178">
                            <a:extLst>
                              <a:ext uri="{FF2B5EF4-FFF2-40B4-BE49-F238E27FC236}">
      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B28519C1-2B29-2640-9859-73301AD2007E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 rot="16200000">
                            <a:off x="6134396" y="4052686"/>
                            <a:ext cx="72000" cy="396000"/>
                          </a:xfrm>
                          <a:prstGeom prst="leftBracket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fr-FR"/>
                          </a:p>
                        </p:txBody>
                      </p:sp>
                    </p:grpSp>
                  </p:grpSp>
                </p:grpSp>
                <p:pic>
                  <p:nvPicPr>
                    <p:cNvPr id="150" name="Image 149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95754ABC-ED44-FA48-87E4-1F35A301E9B5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4"/>
                    <a:srcRect l="8904"/>
                    <a:stretch/>
                  </p:blipFill>
                  <p:spPr>
                    <a:xfrm>
                      <a:off x="5101677" y="4586787"/>
                      <a:ext cx="2534725" cy="1545433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466" name="ZoneTexte 465">
                      <a:extLst>
                        <a:ext uri="{FF2B5EF4-FFF2-40B4-BE49-F238E27FC236}">
  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ADBA89D6-E3CC-BA42-9636-A80CA3E5C463}"/>
                        </a:ext>
                      </a:extLst>
                    </p:cNvPr>
                    <p:cNvSpPr txBox="1"/>
                    <p:nvPr/>
                  </p:nvSpPr>
                  <p:spPr>
                    <a:xfrm rot="16200000">
                      <a:off x="4265605" y="5221004"/>
                      <a:ext cx="1383712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fr-FR" sz="12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ld</a:t>
                      </a:r>
                      <a:r>
                        <a:rPr lang="fr-FR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FR" sz="12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richment</a:t>
                      </a:r>
                      <a:endParaRPr lang="fr-FR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259" name="ZoneTexte 258">
                    <a:extLst>
                      <a:ext uri="{FF2B5EF4-FFF2-40B4-BE49-F238E27FC236}">
    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1893980D-21BE-9B43-AAA0-7263BEAC34F8}"/>
                      </a:ext>
                    </a:extLst>
                  </p:cNvPr>
                  <p:cNvSpPr txBox="1"/>
                  <p:nvPr/>
                </p:nvSpPr>
                <p:spPr>
                  <a:xfrm>
                    <a:off x="7486251" y="6054548"/>
                    <a:ext cx="718466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10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ntibody</a:t>
                    </a:r>
                    <a:endParaRPr lang="fr-FR" sz="10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sp>
            <p:nvSpPr>
              <p:cNvPr id="264" name="ZoneTexte 263"/>
              <p:cNvSpPr txBox="1"/>
              <p:nvPr/>
            </p:nvSpPr>
            <p:spPr>
              <a:xfrm>
                <a:off x="355449" y="4609209"/>
                <a:ext cx="166700" cy="276999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noAutofit/>
              </a:bodyPr>
              <a:lstStyle/>
              <a:p>
                <a:r>
                  <a:rPr lang="fr-FR" b="1" dirty="0" smtClean="0">
                    <a:latin typeface="Arial"/>
                    <a:cs typeface="Arial"/>
                  </a:rPr>
                  <a:t>C</a:t>
                </a:r>
                <a:endParaRPr lang="fr-FR" b="1" dirty="0">
                  <a:latin typeface="Arial"/>
                  <a:cs typeface="Arial"/>
                </a:endParaRPr>
              </a:p>
            </p:txBody>
          </p:sp>
        </p:grpSp>
      </p:grp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37</TotalTime>
  <Words>136</Words>
  <Application>Microsoft Macintosh PowerPoint</Application>
  <PresentationFormat>Format A4 (210 x 297 mm)</PresentationFormat>
  <Paragraphs>117</Paragraphs>
  <Slides>1</Slides>
  <Notes>0</Notes>
  <HiddenSlides>0</HiddenSlides>
  <MMClips>0</MMClips>
  <ScaleCrop>false</ScaleCrop>
  <HeadingPairs>
    <vt:vector size="4" baseType="variant">
      <vt:variant>
        <vt:lpstr>Modèle de conception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nadia benaroudj</dc:creator>
  <cp:lastModifiedBy>nadia benaroudj</cp:lastModifiedBy>
  <cp:revision>16</cp:revision>
  <cp:lastPrinted>2020-01-13T18:35:27Z</cp:lastPrinted>
  <dcterms:created xsi:type="dcterms:W3CDTF">2020-04-03T12:04:37Z</dcterms:created>
  <dcterms:modified xsi:type="dcterms:W3CDTF">2020-04-03T12:09:05Z</dcterms:modified>
</cp:coreProperties>
</file>